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28A4C7E-D212-75F6-8432-BFAC1405E266}" name="Isabella Barbagallo" initials="IB" userId="S::isabellab@kjtgroup.com::9f9c9d83-82b3-482f-a4e7-16c7304ead11" providerId="AD"/>
  <p188:author id="{8042A38D-EB8F-714D-DEB5-24F64CB5ACD7}" name="Melissa Lippa" initials="ML" userId="S::melissal@kjtgroup.com::8894df51-a084-45b4-bef0-e2420097509e" providerId="AD"/>
  <p188:author id="{44FA9AC0-2FFD-0E2C-1D0A-FC25449297C9}" name="Abby Johnson" initials="AJ" userId="S::abbyj@kjtgroup.com::8be898ab-fa96-4784-8070-05ede5d9b11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5A4DE"/>
    <a:srgbClr val="31489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D3F9C63-62D9-4E34-8B8A-8C50BE204738}" v="1" dt="2024-01-03T19:21:47.95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86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becca Hahn" userId="ffd7826c-6135-43c6-87d5-5baf5c9a6cd3" providerId="ADAL" clId="{FD3F9C63-62D9-4E34-8B8A-8C50BE204738}"/>
    <pc:docChg chg="modSld">
      <pc:chgData name="Rebecca Hahn" userId="ffd7826c-6135-43c6-87d5-5baf5c9a6cd3" providerId="ADAL" clId="{FD3F9C63-62D9-4E34-8B8A-8C50BE204738}" dt="2024-01-03T19:23:05.731" v="11"/>
      <pc:docMkLst>
        <pc:docMk/>
      </pc:docMkLst>
      <pc:sldChg chg="mod delCm">
        <pc:chgData name="Rebecca Hahn" userId="ffd7826c-6135-43c6-87d5-5baf5c9a6cd3" providerId="ADAL" clId="{FD3F9C63-62D9-4E34-8B8A-8C50BE204738}" dt="2024-01-03T19:23:05.731" v="11"/>
        <pc:sldMkLst>
          <pc:docMk/>
          <pc:sldMk cId="1115988760" sldId="259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Rebecca Hahn" userId="ffd7826c-6135-43c6-87d5-5baf5c9a6cd3" providerId="ADAL" clId="{FD3F9C63-62D9-4E34-8B8A-8C50BE204738}" dt="2024-01-03T19:22:32.236" v="10"/>
              <pc2:cmMkLst xmlns:pc2="http://schemas.microsoft.com/office/powerpoint/2019/9/main/command">
                <pc:docMk/>
                <pc:sldMk cId="1115988760" sldId="259"/>
                <pc2:cmMk id="{6A58416C-7305-41A2-9814-939C00596962}"/>
              </pc2:cmMkLst>
            </pc226:cmChg>
            <pc226:cmChg xmlns:pc226="http://schemas.microsoft.com/office/powerpoint/2022/06/main/command" chg="del">
              <pc226:chgData name="Rebecca Hahn" userId="ffd7826c-6135-43c6-87d5-5baf5c9a6cd3" providerId="ADAL" clId="{FD3F9C63-62D9-4E34-8B8A-8C50BE204738}" dt="2024-01-03T19:23:05.731" v="11"/>
              <pc2:cmMkLst xmlns:pc2="http://schemas.microsoft.com/office/powerpoint/2019/9/main/command">
                <pc:docMk/>
                <pc:sldMk cId="1115988760" sldId="259"/>
                <pc2:cmMk id="{09550EA6-3110-4197-BA82-8BF578B36CDF}"/>
              </pc2:cmMkLst>
            </pc226:cmChg>
          </p:ext>
        </pc:ext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eries 1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High</c:v>
                </c:pt>
                <c:pt idx="1">
                  <c:v>Intermediate-High</c:v>
                </c:pt>
                <c:pt idx="2">
                  <c:v>Intermediate-Low</c:v>
                </c:pt>
                <c:pt idx="3">
                  <c:v>Low</c:v>
                </c:pt>
              </c:strCache>
            </c:strRef>
          </c:cat>
          <c:val>
            <c:numRef>
              <c:f>Sheet1!$B$2:$B$5</c:f>
              <c:numCache>
                <c:formatCode>0%</c:formatCode>
                <c:ptCount val="4"/>
                <c:pt idx="0">
                  <c:v>0.03</c:v>
                </c:pt>
                <c:pt idx="1">
                  <c:v>0.62</c:v>
                </c:pt>
                <c:pt idx="2">
                  <c:v>0.33</c:v>
                </c:pt>
                <c:pt idx="3">
                  <c:v>0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E4-4CBA-AA40-79A13629D0E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eries 2</c:v>
                </c:pt>
              </c:strCache>
            </c:strRef>
          </c:tx>
          <c:spPr>
            <a:pattFill prst="wdDnDiag">
              <a:fgClr>
                <a:schemeClr val="accent6">
                  <a:lumMod val="75000"/>
                </a:schemeClr>
              </a:fgClr>
              <a:bgClr>
                <a:schemeClr val="bg1"/>
              </a:bgClr>
            </a:pattFill>
            <a:ln>
              <a:solidFill>
                <a:schemeClr val="accent6">
                  <a:lumMod val="75000"/>
                </a:schemeClr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High</c:v>
                </c:pt>
                <c:pt idx="1">
                  <c:v>Intermediate-High</c:v>
                </c:pt>
                <c:pt idx="2">
                  <c:v>Intermediate-Low</c:v>
                </c:pt>
                <c:pt idx="3">
                  <c:v>Low</c:v>
                </c:pt>
              </c:strCache>
            </c:strRef>
          </c:cat>
          <c:val>
            <c:numRef>
              <c:f>Sheet1!$C$2:$C$5</c:f>
              <c:numCache>
                <c:formatCode>0%</c:formatCode>
                <c:ptCount val="4"/>
                <c:pt idx="0">
                  <c:v>0.01</c:v>
                </c:pt>
                <c:pt idx="1">
                  <c:v>0.38</c:v>
                </c:pt>
                <c:pt idx="2">
                  <c:v>0.53</c:v>
                </c:pt>
                <c:pt idx="3">
                  <c:v>0.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7E4-4CBA-AA40-79A13629D0E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068632623"/>
        <c:axId val="1892729440"/>
      </c:barChart>
      <c:catAx>
        <c:axId val="10686326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92729440"/>
        <c:crosses val="autoZero"/>
        <c:auto val="1"/>
        <c:lblAlgn val="ctr"/>
        <c:lblOffset val="100"/>
        <c:noMultiLvlLbl val="0"/>
      </c:catAx>
      <c:valAx>
        <c:axId val="1892729440"/>
        <c:scaling>
          <c:orientation val="minMax"/>
          <c:max val="1"/>
        </c:scaling>
        <c:delete val="1"/>
        <c:axPos val="l"/>
        <c:numFmt formatCode="0%" sourceLinked="1"/>
        <c:majorTickMark val="none"/>
        <c:minorTickMark val="none"/>
        <c:tickLblPos val="nextTo"/>
        <c:crossAx val="10686326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eries 1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</c:strCache>
            </c:strRef>
          </c:cat>
          <c:val>
            <c:numRef>
              <c:f>Sheet1!$B$2:$B$5</c:f>
              <c:numCache>
                <c:formatCode>0%</c:formatCode>
                <c:ptCount val="4"/>
                <c:pt idx="0">
                  <c:v>7.0000000000000007E-2</c:v>
                </c:pt>
                <c:pt idx="1">
                  <c:v>0.27</c:v>
                </c:pt>
                <c:pt idx="2">
                  <c:v>0.59</c:v>
                </c:pt>
                <c:pt idx="3">
                  <c:v>0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E4-4CBA-AA40-79A13629D0E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eries 2</c:v>
                </c:pt>
              </c:strCache>
            </c:strRef>
          </c:tx>
          <c:spPr>
            <a:pattFill prst="wdDnDiag">
              <a:fgClr>
                <a:schemeClr val="accent4">
                  <a:lumMod val="75000"/>
                </a:schemeClr>
              </a:fgClr>
              <a:bgClr>
                <a:schemeClr val="bg1"/>
              </a:bgClr>
            </a:pattFill>
            <a:ln>
              <a:solidFill>
                <a:schemeClr val="accent4">
                  <a:lumMod val="75000"/>
                </a:schemeClr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</c:strCache>
            </c:strRef>
          </c:cat>
          <c:val>
            <c:numRef>
              <c:f>Sheet1!$C$2:$C$5</c:f>
              <c:numCache>
                <c:formatCode>0%</c:formatCode>
                <c:ptCount val="4"/>
                <c:pt idx="0">
                  <c:v>0.08</c:v>
                </c:pt>
                <c:pt idx="1">
                  <c:v>0.54</c:v>
                </c:pt>
                <c:pt idx="2">
                  <c:v>0.35</c:v>
                </c:pt>
                <c:pt idx="3">
                  <c:v>0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7E4-4CBA-AA40-79A13629D0E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068632623"/>
        <c:axId val="1892729440"/>
      </c:barChart>
      <c:catAx>
        <c:axId val="10686326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92729440"/>
        <c:crosses val="autoZero"/>
        <c:auto val="1"/>
        <c:lblAlgn val="ctr"/>
        <c:lblOffset val="100"/>
        <c:noMultiLvlLbl val="0"/>
      </c:catAx>
      <c:valAx>
        <c:axId val="1892729440"/>
        <c:scaling>
          <c:orientation val="minMax"/>
          <c:max val="1"/>
        </c:scaling>
        <c:delete val="1"/>
        <c:axPos val="l"/>
        <c:numFmt formatCode="0%" sourceLinked="1"/>
        <c:majorTickMark val="out"/>
        <c:minorTickMark val="none"/>
        <c:tickLblPos val="nextTo"/>
        <c:crossAx val="10686326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eries 1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9C4AA13D-4F6A-45FB-B8D5-D497A63A1DE2}" type="VALUE">
                      <a:rPr lang="en-US" smtClean="0"/>
                      <a:pPr/>
                      <a:t>[VALUE]</a:t>
                    </a:fld>
                    <a:r>
                      <a:rPr lang="en-US"/>
                      <a:t>m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D075-4E3C-9885-5356D2E3B36E}"/>
                </c:ext>
              </c:extLst>
            </c:dLbl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</c:f>
              <c:strCache>
                <c:ptCount val="1"/>
                <c:pt idx="0">
                  <c:v>6MWD</c:v>
                </c:pt>
              </c:strCache>
            </c:strRef>
          </c:cat>
          <c:val>
            <c:numRef>
              <c:f>Sheet1!$B$2</c:f>
              <c:numCache>
                <c:formatCode>0.00</c:formatCode>
                <c:ptCount val="1"/>
                <c:pt idx="0">
                  <c:v>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E4-4CBA-AA40-79A13629D0E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eries 2</c:v>
                </c:pt>
              </c:strCache>
            </c:strRef>
          </c:tx>
          <c:spPr>
            <a:pattFill prst="wdDnDiag">
              <a:fgClr>
                <a:schemeClr val="accent2">
                  <a:lumMod val="75000"/>
                </a:schemeClr>
              </a:fgClr>
              <a:bgClr>
                <a:schemeClr val="bg1"/>
              </a:bgClr>
            </a:pattFill>
            <a:ln>
              <a:solidFill>
                <a:schemeClr val="accent2">
                  <a:lumMod val="75000"/>
                </a:schemeClr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D28C53F2-1F92-4B24-BA09-AD49F8D827B3}" type="VALUE">
                      <a:rPr lang="en-US" smtClean="0"/>
                      <a:pPr/>
                      <a:t>[VALUE]</a:t>
                    </a:fld>
                    <a:r>
                      <a:rPr lang="en-US"/>
                      <a:t>m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D075-4E3C-9885-5356D2E3B36E}"/>
                </c:ext>
              </c:extLst>
            </c:dLbl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</c:f>
              <c:strCache>
                <c:ptCount val="1"/>
                <c:pt idx="0">
                  <c:v>6MWD</c:v>
                </c:pt>
              </c:strCache>
            </c:strRef>
          </c:cat>
          <c:val>
            <c:numRef>
              <c:f>Sheet1!$C$2</c:f>
              <c:numCache>
                <c:formatCode>0.00</c:formatCode>
                <c:ptCount val="1"/>
                <c:pt idx="0">
                  <c:v>3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7E4-4CBA-AA40-79A13629D0E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068632623"/>
        <c:axId val="1892729440"/>
      </c:barChart>
      <c:catAx>
        <c:axId val="10686326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92729440"/>
        <c:crosses val="autoZero"/>
        <c:auto val="1"/>
        <c:lblAlgn val="ctr"/>
        <c:lblOffset val="100"/>
        <c:noMultiLvlLbl val="0"/>
      </c:catAx>
      <c:valAx>
        <c:axId val="1892729440"/>
        <c:scaling>
          <c:orientation val="minMax"/>
        </c:scaling>
        <c:delete val="1"/>
        <c:axPos val="l"/>
        <c:numFmt formatCode="0.00" sourceLinked="1"/>
        <c:majorTickMark val="out"/>
        <c:minorTickMark val="none"/>
        <c:tickLblPos val="nextTo"/>
        <c:crossAx val="10686326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eries 1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 rot="0" spcFirstLastPara="1" vertOverflow="ellipsis" vert="horz" wrap="none" lIns="38100" tIns="19050" rIns="38100" bIns="19050" anchor="ctr" anchorCtr="1">
                    <a:spAutoFit/>
                  </a:bodyPr>
                  <a:lstStyle/>
                  <a:p>
                    <a:pPr>
                      <a:defRPr sz="1197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9C4AA13D-4F6A-45FB-B8D5-D497A63A1DE2}" type="VALUE">
                      <a:rPr lang="en-US" smtClean="0"/>
                      <a:pPr>
                        <a:defRPr sz="1197" b="0" i="0" u="none" strike="noStrike" kern="1200" baseline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t>[VALUE]</a:t>
                    </a:fld>
                    <a:r>
                      <a:rPr lang="en-US" dirty="0"/>
                      <a:t>ng/l*</a:t>
                    </a:r>
                  </a:p>
                </c:rich>
              </c:tx>
              <c:numFmt formatCode="#,##0" sourceLinked="0"/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D075-4E3C-9885-5356D2E3B36E}"/>
                </c:ext>
              </c:extLst>
            </c:dLbl>
            <c:dLbl>
              <c:idx val="1"/>
              <c:tx>
                <c:rich>
                  <a:bodyPr rot="0" spcFirstLastPara="1" vertOverflow="ellipsis" vert="horz" wrap="none" lIns="38100" tIns="19050" rIns="38100" bIns="19050" anchor="ctr" anchorCtr="1">
                    <a:spAutoFit/>
                  </a:bodyPr>
                  <a:lstStyle/>
                  <a:p>
                    <a:pPr>
                      <a:defRPr sz="1197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5DE659E4-627E-4375-8699-E47D296B7022}" type="VALUE">
                      <a:rPr lang="en-US" smtClean="0"/>
                      <a:pPr>
                        <a:defRPr sz="1197" b="0" i="0" u="none" strike="noStrike" kern="1200" baseline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t>[VALUE]</a:t>
                    </a:fld>
                    <a:r>
                      <a:rPr lang="en-US"/>
                      <a:t>ng/l*</a:t>
                    </a:r>
                  </a:p>
                </c:rich>
              </c:tx>
              <c:numFmt formatCode="#,##0" sourceLinked="0"/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3BD0-47ED-81A6-31DC143B1604}"/>
                </c:ext>
              </c:extLst>
            </c:dLbl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3</c:f>
              <c:strCache>
                <c:ptCount val="2"/>
                <c:pt idx="0">
                  <c:v>BNP</c:v>
                </c:pt>
                <c:pt idx="1">
                  <c:v>NT-proBNP</c:v>
                </c:pt>
              </c:strCache>
            </c:strRef>
          </c:cat>
          <c:val>
            <c:numRef>
              <c:f>Sheet1!$B$2:$B$3</c:f>
              <c:numCache>
                <c:formatCode>0.00</c:formatCode>
                <c:ptCount val="2"/>
                <c:pt idx="0">
                  <c:v>210</c:v>
                </c:pt>
                <c:pt idx="1">
                  <c:v>68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E4-4CBA-AA40-79A13629D0E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eries 2</c:v>
                </c:pt>
              </c:strCache>
            </c:strRef>
          </c:tx>
          <c:spPr>
            <a:pattFill prst="wdDnDiag">
              <a:fgClr>
                <a:schemeClr val="accent5">
                  <a:lumMod val="75000"/>
                </a:schemeClr>
              </a:fgClr>
              <a:bgClr>
                <a:schemeClr val="bg1"/>
              </a:bgClr>
            </a:pattFill>
            <a:ln>
              <a:solidFill>
                <a:schemeClr val="accent5">
                  <a:lumMod val="75000"/>
                </a:schemeClr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 rot="0" spcFirstLastPara="1" vertOverflow="ellipsis" vert="horz" wrap="none" lIns="38100" tIns="19050" rIns="38100" bIns="19050" anchor="ctr" anchorCtr="1">
                    <a:spAutoFit/>
                  </a:bodyPr>
                  <a:lstStyle/>
                  <a:p>
                    <a:pPr>
                      <a:defRPr sz="1197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D28C53F2-1F92-4B24-BA09-AD49F8D827B3}" type="VALUE">
                      <a:rPr lang="en-US" smtClean="0"/>
                      <a:pPr>
                        <a:defRPr sz="1197" b="0" i="0" u="none" strike="noStrike" kern="1200" baseline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t>[VALUE]</a:t>
                    </a:fld>
                    <a:r>
                      <a:rPr lang="en-US" dirty="0"/>
                      <a:t>ng/l*</a:t>
                    </a:r>
                  </a:p>
                </c:rich>
              </c:tx>
              <c:numFmt formatCode="#,##0" sourceLinked="0"/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D075-4E3C-9885-5356D2E3B36E}"/>
                </c:ext>
              </c:extLst>
            </c:dLbl>
            <c:dLbl>
              <c:idx val="1"/>
              <c:tx>
                <c:rich>
                  <a:bodyPr rot="0" spcFirstLastPara="1" vertOverflow="ellipsis" vert="horz" wrap="none" lIns="38100" tIns="19050" rIns="38100" bIns="19050" anchor="ctr" anchorCtr="1">
                    <a:spAutoFit/>
                  </a:bodyPr>
                  <a:lstStyle/>
                  <a:p>
                    <a:pPr>
                      <a:defRPr sz="1197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CA333AF9-8EAA-4F33-BEFC-DD09D08FCFB4}" type="VALUE">
                      <a:rPr lang="en-US" smtClean="0"/>
                      <a:pPr>
                        <a:defRPr sz="1197" b="0" i="0" u="none" strike="noStrike" kern="1200" baseline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t>[VALUE]</a:t>
                    </a:fld>
                    <a:r>
                      <a:rPr lang="en-US"/>
                      <a:t>ng/l*</a:t>
                    </a:r>
                  </a:p>
                </c:rich>
              </c:tx>
              <c:numFmt formatCode="#,##0" sourceLinked="0"/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3BD0-47ED-81A6-31DC143B1604}"/>
                </c:ext>
              </c:extLst>
            </c:dLbl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3</c:f>
              <c:strCache>
                <c:ptCount val="2"/>
                <c:pt idx="0">
                  <c:v>BNP</c:v>
                </c:pt>
                <c:pt idx="1">
                  <c:v>NT-proBNP</c:v>
                </c:pt>
              </c:strCache>
            </c:strRef>
          </c:cat>
          <c:val>
            <c:numRef>
              <c:f>Sheet1!$C$2:$C$3</c:f>
              <c:numCache>
                <c:formatCode>0.00</c:formatCode>
                <c:ptCount val="2"/>
                <c:pt idx="0">
                  <c:v>153</c:v>
                </c:pt>
                <c:pt idx="1">
                  <c:v>5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7E4-4CBA-AA40-79A13629D0E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068632623"/>
        <c:axId val="1892729440"/>
      </c:barChart>
      <c:catAx>
        <c:axId val="10686326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92729440"/>
        <c:crosses val="autoZero"/>
        <c:auto val="1"/>
        <c:lblAlgn val="ctr"/>
        <c:lblOffset val="100"/>
        <c:noMultiLvlLbl val="0"/>
      </c:catAx>
      <c:valAx>
        <c:axId val="1892729440"/>
        <c:scaling>
          <c:orientation val="minMax"/>
        </c:scaling>
        <c:delete val="1"/>
        <c:axPos val="l"/>
        <c:numFmt formatCode="0.00" sourceLinked="1"/>
        <c:majorTickMark val="out"/>
        <c:minorTickMark val="none"/>
        <c:tickLblPos val="nextTo"/>
        <c:crossAx val="10686326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220C5-A458-896F-9E46-0352B89729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51E12E-63A0-E942-6DA1-8C55253360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0FC06D-8DEB-AB99-4E77-A94B18C5A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23A4D3-6D18-BD21-4E86-E9532A80B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DC061A-8521-F68C-C0D4-3C62F0A41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489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4699FE-4763-F543-8281-53D599EF49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E79DBF-DBCB-4DD9-56B2-66D2CA0F3C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1DE59-0AA9-0D3A-A95A-C41AB24ED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1DDBCE-9B68-9171-54D1-3DC420CDC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D7E965-D7B8-68EC-785C-24E7C6017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417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3F7500-87D4-FBB2-455D-EA7AB467AF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B70B00-A487-B77D-F2CE-88EC38EC07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BB010F-FAA7-7CF3-D2F7-70A67A23F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5E68E-4FFE-5E91-E852-A88E41A93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015555-9DF3-EDC7-827C-432CE42293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74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DFE930-6523-D89B-9842-80D8F0F2A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7464F4-8A7A-246E-687A-4FDF50F1D0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4B0C42-F915-660E-B065-DA277308E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70D281-797F-27FF-62EC-0AC3209BB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958374-F582-85CE-0F1F-B3F1784E1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888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42095-8B52-C1EA-DD53-76CDF0F318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73AE2D-5390-1D9B-64F2-886B92EA8A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97DE72-5300-5461-6B3A-BCFDD09E9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5E0A19-E6DC-80EC-789F-1522D88F7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2501C0-9571-D7C9-60E7-9675C32693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684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B7ED5-BDAB-EC8B-0322-7EAD1FB397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D7996D-D301-8C7A-7858-8F34DC3372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7BCF1D-E862-A95F-8A3E-7F4EEB3660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FAA1CB-0982-FE8F-C502-C8D37790E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A180F9-0718-DAA6-DB37-7ADD6DD8F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CA582D-4B34-F015-F312-39F7F9665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950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13FB40-0917-2D8E-94E9-11BF38A57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C41575-B935-8CB3-5CFC-D1C53DB314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755080-63DA-D438-729D-BB31838338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42DAA5-7B9A-FC0F-DF0C-FEA32DC3B8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6E9708-870B-34D5-D1C5-793792C7ED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89C3CE-102D-3D42-BFAD-441C4EA11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1FAE630-4C70-242D-6120-521DAE917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6C5548-BB15-5AF0-61B5-7FEF8A451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16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A04297-19FA-69F1-DBB9-6B38279E5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31A64C-CA60-6099-C9BF-F5AF37049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829FE4-47A7-1C80-394F-62B9CA0E5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0B89FC-CF71-9674-DA5E-1B3A991C33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182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60B0D9-8B5C-F6C0-2FB0-5051FB912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95D0CA7-7619-9E31-B898-15155A407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AB46E6-58F5-4455-7513-3C8D3A0B7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330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C0F8E-7431-C957-055F-3D20FDEA6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F1B198-7D37-EC74-6C9D-26A72FE86A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DF0358-42A6-3D8C-4C89-A7BDEBB03F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A2922F-9236-9EA7-B4CD-2626579DA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40CD19-8FFF-E757-D07E-BCB8AAEBF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802D22-3579-D2A6-1DF1-1C9816D34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758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393F32-742B-52F4-8689-6820A9957A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0DA36D-330F-DC4D-DBA9-B462A22689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2AC63C-BE13-DE7D-AD9D-2E43005D39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2B748B-C108-86CE-71CC-AD0856143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CC959E-D10A-7220-B6A5-575668ED2A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43EF80-ECAD-E78E-1215-D68233F97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28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CA01196-6F67-9253-98AD-1107B88857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8C1847-8509-306C-5AA4-0A3CD41AD9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06B69B-9696-AD4F-3892-8FE98AA4EC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98F2A-36CC-4CFE-9842-22A86378B94C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3DF59-C97C-ED27-13A4-FA59C8A598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FEE0A0-F518-2B1C-A3BC-103435E9A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AAA05-C3C2-4E65-8DAA-3F8911041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165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8.svg"/><Relationship Id="rId3" Type="http://schemas.openxmlformats.org/officeDocument/2006/relationships/chart" Target="../charts/chart2.xml"/><Relationship Id="rId7" Type="http://schemas.openxmlformats.org/officeDocument/2006/relationships/image" Target="../media/image2.svg"/><Relationship Id="rId12" Type="http://schemas.openxmlformats.org/officeDocument/2006/relationships/image" Target="../media/image7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11" Type="http://schemas.openxmlformats.org/officeDocument/2006/relationships/image" Target="../media/image6.svg"/><Relationship Id="rId5" Type="http://schemas.openxmlformats.org/officeDocument/2006/relationships/chart" Target="../charts/chart4.xml"/><Relationship Id="rId15" Type="http://schemas.openxmlformats.org/officeDocument/2006/relationships/image" Target="../media/image10.svg"/><Relationship Id="rId10" Type="http://schemas.openxmlformats.org/officeDocument/2006/relationships/image" Target="../media/image5.png"/><Relationship Id="rId4" Type="http://schemas.openxmlformats.org/officeDocument/2006/relationships/chart" Target="../charts/chart3.xml"/><Relationship Id="rId9" Type="http://schemas.openxmlformats.org/officeDocument/2006/relationships/image" Target="../media/image4.sv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59EFD0B-F7F7-BB54-0752-F90D0BD99D48}"/>
              </a:ext>
            </a:extLst>
          </p:cNvPr>
          <p:cNvSpPr txBox="1"/>
          <p:nvPr/>
        </p:nvSpPr>
        <p:spPr>
          <a:xfrm>
            <a:off x="84670" y="84670"/>
            <a:ext cx="10888130" cy="11233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2000" b="1" dirty="0">
                <a:latin typeface="+mj-lt"/>
              </a:rPr>
              <a:t>Real-world assessment of parenteral prostacyclin therapy in patients with intermediate-risk PAH</a:t>
            </a:r>
          </a:p>
          <a:p>
            <a:pPr>
              <a:spcAft>
                <a:spcPts val="600"/>
              </a:spcAft>
            </a:pPr>
            <a:r>
              <a:rPr lang="en-US" sz="1400" dirty="0"/>
              <a:t>A retrospective chart review and cross-sectional survey of HCPs </a:t>
            </a:r>
            <a:br>
              <a:rPr lang="en-US" sz="1400" dirty="0"/>
            </a:br>
            <a:r>
              <a:rPr lang="en-US" sz="1400" dirty="0"/>
              <a:t>to assess parenteral prostacyclin therapy use among patients at </a:t>
            </a:r>
            <a:br>
              <a:rPr lang="en-US" sz="1400" dirty="0"/>
            </a:br>
            <a:r>
              <a:rPr lang="en-US" sz="1400" dirty="0"/>
              <a:t>intermediate risk according to the COMPERA 2.0 risk calculato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EA419D4-34E0-49EA-5DAB-EEA08CB71FC0}"/>
              </a:ext>
            </a:extLst>
          </p:cNvPr>
          <p:cNvSpPr txBox="1"/>
          <p:nvPr/>
        </p:nvSpPr>
        <p:spPr>
          <a:xfrm>
            <a:off x="84668" y="6404758"/>
            <a:ext cx="11558087" cy="369332"/>
          </a:xfrm>
          <a:prstGeom prst="rect">
            <a:avLst/>
          </a:prstGeom>
          <a:noFill/>
        </p:spPr>
        <p:txBody>
          <a:bodyPr wrap="square" anchor="b">
            <a:spAutoFit/>
          </a:bodyPr>
          <a:lstStyle/>
          <a:p>
            <a:r>
              <a:rPr lang="en-US" sz="9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*Median. Abbreviations: BNP/NT-proBNP, B-type natriuretic peptide/aminoterminal pro B-type natriuretic peptide; COMPERA 2.0, Comparative, Prospective Registry of Newly Initiated Therapies for Pulmonary Hypertension 2.0 four-strata risk assessment model; FC, Functional Class; HCP, healthcare professional; PAH, pulmonary arterial hypertension; PH, pulmonary hypertension; WHO, World Health Organization; 6MWD, 6-minute walk distance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E5F53A5-D7EA-AFD9-4C06-8C4BB25F5E17}"/>
              </a:ext>
            </a:extLst>
          </p:cNvPr>
          <p:cNvGrpSpPr/>
          <p:nvPr/>
        </p:nvGrpSpPr>
        <p:grpSpPr>
          <a:xfrm>
            <a:off x="5430151" y="580461"/>
            <a:ext cx="5915415" cy="663427"/>
            <a:chOff x="5681661" y="780562"/>
            <a:chExt cx="5915415" cy="663427"/>
          </a:xfrm>
        </p:grpSpPr>
        <p:sp>
          <p:nvSpPr>
            <p:cNvPr id="13" name="Rectangle: Rounded Corners 12">
              <a:extLst>
                <a:ext uri="{FF2B5EF4-FFF2-40B4-BE49-F238E27FC236}">
                  <a16:creationId xmlns:a16="http://schemas.microsoft.com/office/drawing/2014/main" id="{9AB3BA78-C86C-D21F-1F53-EBD9321C32AC}"/>
                </a:ext>
              </a:extLst>
            </p:cNvPr>
            <p:cNvSpPr/>
            <p:nvPr/>
          </p:nvSpPr>
          <p:spPr>
            <a:xfrm>
              <a:off x="5681661" y="780562"/>
              <a:ext cx="3903131" cy="663427"/>
            </a:xfrm>
            <a:prstGeom prst="roundRect">
              <a:avLst>
                <a:gd name="adj" fmla="val 50000"/>
              </a:avLst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571500"/>
              <a:r>
                <a:rPr lang="en-US" sz="2800" dirty="0">
                  <a:latin typeface="+mj-lt"/>
                </a:rPr>
                <a:t>139 HCPs</a:t>
              </a:r>
            </a:p>
          </p:txBody>
        </p:sp>
        <p:sp>
          <p:nvSpPr>
            <p:cNvPr id="14" name="Rectangle: Rounded Corners 13">
              <a:extLst>
                <a:ext uri="{FF2B5EF4-FFF2-40B4-BE49-F238E27FC236}">
                  <a16:creationId xmlns:a16="http://schemas.microsoft.com/office/drawing/2014/main" id="{76E6EAD7-308C-D9BA-51AD-9BEBCE148377}"/>
                </a:ext>
              </a:extLst>
            </p:cNvPr>
            <p:cNvSpPr/>
            <p:nvPr/>
          </p:nvSpPr>
          <p:spPr>
            <a:xfrm>
              <a:off x="8107415" y="780562"/>
              <a:ext cx="3489661" cy="663427"/>
            </a:xfrm>
            <a:prstGeom prst="roundRect">
              <a:avLst>
                <a:gd name="adj" fmla="val 50000"/>
              </a:avLst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600" dirty="0"/>
                <a:t>participated in the survey and provided </a:t>
              </a:r>
              <a:r>
                <a:rPr lang="en-US" sz="1600" dirty="0">
                  <a:latin typeface="+mj-lt"/>
                </a:rPr>
                <a:t>350 patient records</a:t>
              </a:r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9C3B6E8E-BFE3-0B67-26E8-4EC220064E3B}"/>
                </a:ext>
              </a:extLst>
            </p:cNvPr>
            <p:cNvSpPr/>
            <p:nvPr/>
          </p:nvSpPr>
          <p:spPr>
            <a:xfrm>
              <a:off x="5761298" y="845575"/>
              <a:ext cx="533400" cy="533400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6" name="Graphic 4">
              <a:extLst>
                <a:ext uri="{FF2B5EF4-FFF2-40B4-BE49-F238E27FC236}">
                  <a16:creationId xmlns:a16="http://schemas.microsoft.com/office/drawing/2014/main" id="{944D4099-AF53-99C9-BA09-52AED973007E}"/>
                </a:ext>
              </a:extLst>
            </p:cNvPr>
            <p:cNvGrpSpPr/>
            <p:nvPr/>
          </p:nvGrpSpPr>
          <p:grpSpPr>
            <a:xfrm>
              <a:off x="5873038" y="903231"/>
              <a:ext cx="309919" cy="418088"/>
              <a:chOff x="3344601" y="1557919"/>
              <a:chExt cx="309919" cy="418088"/>
            </a:xfrm>
          </p:grpSpPr>
          <p:sp>
            <p:nvSpPr>
              <p:cNvPr id="17" name="Freeform: Shape 16">
                <a:extLst>
                  <a:ext uri="{FF2B5EF4-FFF2-40B4-BE49-F238E27FC236}">
                    <a16:creationId xmlns:a16="http://schemas.microsoft.com/office/drawing/2014/main" id="{21CC6658-F487-23A3-7A92-8264FCB38D80}"/>
                  </a:ext>
                </a:extLst>
              </p:cNvPr>
              <p:cNvSpPr/>
              <p:nvPr/>
            </p:nvSpPr>
            <p:spPr>
              <a:xfrm>
                <a:off x="3476399" y="1832519"/>
                <a:ext cx="46416" cy="13973"/>
              </a:xfrm>
              <a:custGeom>
                <a:avLst/>
                <a:gdLst>
                  <a:gd name="connsiteX0" fmla="*/ 46416 w 46416"/>
                  <a:gd name="connsiteY0" fmla="*/ 0 h 13973"/>
                  <a:gd name="connsiteX1" fmla="*/ 38529 w 46416"/>
                  <a:gd name="connsiteY1" fmla="*/ 7731 h 13973"/>
                  <a:gd name="connsiteX2" fmla="*/ 7887 w 46416"/>
                  <a:gd name="connsiteY2" fmla="*/ 7731 h 13973"/>
                  <a:gd name="connsiteX3" fmla="*/ 0 w 46416"/>
                  <a:gd name="connsiteY3" fmla="*/ 0 h 139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6416" h="13973">
                    <a:moveTo>
                      <a:pt x="46416" y="0"/>
                    </a:moveTo>
                    <a:lnTo>
                      <a:pt x="38529" y="7731"/>
                    </a:lnTo>
                    <a:cubicBezTo>
                      <a:pt x="30019" y="16054"/>
                      <a:pt x="16397" y="16054"/>
                      <a:pt x="7887" y="7731"/>
                    </a:cubicBezTo>
                    <a:lnTo>
                      <a:pt x="0" y="0"/>
                    </a:lnTo>
                  </a:path>
                </a:pathLst>
              </a:custGeom>
              <a:noFill/>
              <a:ln w="9347" cap="rnd">
                <a:solidFill>
                  <a:schemeClr val="bg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8" name="Freeform: Shape 17">
                <a:extLst>
                  <a:ext uri="{FF2B5EF4-FFF2-40B4-BE49-F238E27FC236}">
                    <a16:creationId xmlns:a16="http://schemas.microsoft.com/office/drawing/2014/main" id="{5BF724B9-C9D4-2128-BE56-889C61FEC349}"/>
                  </a:ext>
                </a:extLst>
              </p:cNvPr>
              <p:cNvSpPr/>
              <p:nvPr/>
            </p:nvSpPr>
            <p:spPr>
              <a:xfrm>
                <a:off x="3461779" y="1842931"/>
                <a:ext cx="75656" cy="133076"/>
              </a:xfrm>
              <a:custGeom>
                <a:avLst/>
                <a:gdLst>
                  <a:gd name="connsiteX0" fmla="*/ 49814 w 75656"/>
                  <a:gd name="connsiteY0" fmla="*/ 0 h 133076"/>
                  <a:gd name="connsiteX1" fmla="*/ 75656 w 75656"/>
                  <a:gd name="connsiteY1" fmla="*/ 94952 h 133076"/>
                  <a:gd name="connsiteX2" fmla="*/ 37813 w 75656"/>
                  <a:gd name="connsiteY2" fmla="*/ 133076 h 133076"/>
                  <a:gd name="connsiteX3" fmla="*/ 0 w 75656"/>
                  <a:gd name="connsiteY3" fmla="*/ 94952 h 133076"/>
                  <a:gd name="connsiteX4" fmla="*/ 25842 w 75656"/>
                  <a:gd name="connsiteY4" fmla="*/ 0 h 1330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5656" h="133076">
                    <a:moveTo>
                      <a:pt x="49814" y="0"/>
                    </a:moveTo>
                    <a:lnTo>
                      <a:pt x="75656" y="94952"/>
                    </a:lnTo>
                    <a:lnTo>
                      <a:pt x="37813" y="133076"/>
                    </a:lnTo>
                    <a:lnTo>
                      <a:pt x="0" y="94952"/>
                    </a:lnTo>
                    <a:lnTo>
                      <a:pt x="25842" y="0"/>
                    </a:lnTo>
                  </a:path>
                </a:pathLst>
              </a:custGeom>
              <a:noFill/>
              <a:ln w="9347" cap="rnd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19" name="Freeform: Shape 18">
                <a:extLst>
                  <a:ext uri="{FF2B5EF4-FFF2-40B4-BE49-F238E27FC236}">
                    <a16:creationId xmlns:a16="http://schemas.microsoft.com/office/drawing/2014/main" id="{BE7E0BFF-BC83-06E0-0CD7-D4523C466B63}"/>
                  </a:ext>
                </a:extLst>
              </p:cNvPr>
              <p:cNvSpPr/>
              <p:nvPr/>
            </p:nvSpPr>
            <p:spPr>
              <a:xfrm>
                <a:off x="3461779" y="1842931"/>
                <a:ext cx="75656" cy="133076"/>
              </a:xfrm>
              <a:custGeom>
                <a:avLst/>
                <a:gdLst>
                  <a:gd name="connsiteX0" fmla="*/ 49814 w 75656"/>
                  <a:gd name="connsiteY0" fmla="*/ 0 h 133076"/>
                  <a:gd name="connsiteX1" fmla="*/ 75656 w 75656"/>
                  <a:gd name="connsiteY1" fmla="*/ 94952 h 133076"/>
                  <a:gd name="connsiteX2" fmla="*/ 37813 w 75656"/>
                  <a:gd name="connsiteY2" fmla="*/ 133076 h 133076"/>
                  <a:gd name="connsiteX3" fmla="*/ 0 w 75656"/>
                  <a:gd name="connsiteY3" fmla="*/ 94952 h 133076"/>
                  <a:gd name="connsiteX4" fmla="*/ 25842 w 75656"/>
                  <a:gd name="connsiteY4" fmla="*/ 0 h 1330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5656" h="133076">
                    <a:moveTo>
                      <a:pt x="49814" y="0"/>
                    </a:moveTo>
                    <a:lnTo>
                      <a:pt x="75656" y="94952"/>
                    </a:lnTo>
                    <a:lnTo>
                      <a:pt x="37813" y="133076"/>
                    </a:lnTo>
                    <a:lnTo>
                      <a:pt x="0" y="94952"/>
                    </a:lnTo>
                    <a:lnTo>
                      <a:pt x="25842" y="0"/>
                    </a:lnTo>
                  </a:path>
                </a:pathLst>
              </a:custGeom>
              <a:noFill/>
              <a:ln w="9347" cap="rnd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grpSp>
            <p:nvGrpSpPr>
              <p:cNvPr id="20" name="Graphic 4">
                <a:extLst>
                  <a:ext uri="{FF2B5EF4-FFF2-40B4-BE49-F238E27FC236}">
                    <a16:creationId xmlns:a16="http://schemas.microsoft.com/office/drawing/2014/main" id="{42BE3338-9741-F2FB-5E45-79241FB3D1DA}"/>
                  </a:ext>
                </a:extLst>
              </p:cNvPr>
              <p:cNvGrpSpPr/>
              <p:nvPr/>
            </p:nvGrpSpPr>
            <p:grpSpPr>
              <a:xfrm>
                <a:off x="3344601" y="1672635"/>
                <a:ext cx="309919" cy="264344"/>
                <a:chOff x="3344601" y="1672635"/>
                <a:chExt cx="309919" cy="264344"/>
              </a:xfrm>
              <a:noFill/>
            </p:grpSpPr>
            <p:sp>
              <p:nvSpPr>
                <p:cNvPr id="31" name="Freeform: Shape 30">
                  <a:extLst>
                    <a:ext uri="{FF2B5EF4-FFF2-40B4-BE49-F238E27FC236}">
                      <a16:creationId xmlns:a16="http://schemas.microsoft.com/office/drawing/2014/main" id="{F4DE75A6-F3FE-4B91-441C-9DBF83112467}"/>
                    </a:ext>
                  </a:extLst>
                </p:cNvPr>
                <p:cNvSpPr/>
                <p:nvPr/>
              </p:nvSpPr>
              <p:spPr>
                <a:xfrm>
                  <a:off x="3539898" y="1672635"/>
                  <a:ext cx="114621" cy="264344"/>
                </a:xfrm>
                <a:custGeom>
                  <a:avLst/>
                  <a:gdLst>
                    <a:gd name="connsiteX0" fmla="*/ 23224 w 114621"/>
                    <a:gd name="connsiteY0" fmla="*/ 264345 h 264344"/>
                    <a:gd name="connsiteX1" fmla="*/ 114622 w 114621"/>
                    <a:gd name="connsiteY1" fmla="*/ 245423 h 264344"/>
                    <a:gd name="connsiteX2" fmla="*/ 102527 w 114621"/>
                    <a:gd name="connsiteY2" fmla="*/ 184917 h 264344"/>
                    <a:gd name="connsiteX3" fmla="*/ 82109 w 114621"/>
                    <a:gd name="connsiteY3" fmla="*/ 150751 h 264344"/>
                    <a:gd name="connsiteX4" fmla="*/ 62096 w 114621"/>
                    <a:gd name="connsiteY4" fmla="*/ 140246 h 264344"/>
                    <a:gd name="connsiteX5" fmla="*/ 10443 w 114621"/>
                    <a:gd name="connsiteY5" fmla="*/ 125252 h 264344"/>
                    <a:gd name="connsiteX6" fmla="*/ 7294 w 114621"/>
                    <a:gd name="connsiteY6" fmla="*/ 123787 h 264344"/>
                    <a:gd name="connsiteX7" fmla="*/ 2400 w 114621"/>
                    <a:gd name="connsiteY7" fmla="*/ 115776 h 264344"/>
                    <a:gd name="connsiteX8" fmla="*/ 0 w 114621"/>
                    <a:gd name="connsiteY8" fmla="*/ 95326 h 264344"/>
                    <a:gd name="connsiteX9" fmla="*/ 30300 w 114621"/>
                    <a:gd name="connsiteY9" fmla="*/ 47694 h 264344"/>
                    <a:gd name="connsiteX10" fmla="*/ 46603 w 114621"/>
                    <a:gd name="connsiteY10" fmla="*/ 23691 h 264344"/>
                    <a:gd name="connsiteX11" fmla="*/ 32357 w 114621"/>
                    <a:gd name="connsiteY11" fmla="*/ 0 h 26434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</a:cxnLst>
                  <a:rect l="l" t="t" r="r" b="b"/>
                  <a:pathLst>
                    <a:path w="114621" h="264344">
                      <a:moveTo>
                        <a:pt x="23224" y="264345"/>
                      </a:moveTo>
                      <a:lnTo>
                        <a:pt x="114622" y="245423"/>
                      </a:lnTo>
                      <a:lnTo>
                        <a:pt x="102527" y="184917"/>
                      </a:lnTo>
                      <a:cubicBezTo>
                        <a:pt x="99846" y="171575"/>
                        <a:pt x="92614" y="159448"/>
                        <a:pt x="82109" y="150751"/>
                      </a:cubicBezTo>
                      <a:cubicBezTo>
                        <a:pt x="75376" y="145234"/>
                        <a:pt x="68580" y="141680"/>
                        <a:pt x="62096" y="140246"/>
                      </a:cubicBezTo>
                      <a:lnTo>
                        <a:pt x="10443" y="125252"/>
                      </a:lnTo>
                      <a:cubicBezTo>
                        <a:pt x="9321" y="124940"/>
                        <a:pt x="8261" y="124441"/>
                        <a:pt x="7294" y="123787"/>
                      </a:cubicBezTo>
                      <a:cubicBezTo>
                        <a:pt x="4582" y="121948"/>
                        <a:pt x="2774" y="119017"/>
                        <a:pt x="2400" y="115776"/>
                      </a:cubicBezTo>
                      <a:lnTo>
                        <a:pt x="0" y="95326"/>
                      </a:lnTo>
                      <a:cubicBezTo>
                        <a:pt x="14464" y="84104"/>
                        <a:pt x="25156" y="67302"/>
                        <a:pt x="30300" y="47694"/>
                      </a:cubicBezTo>
                      <a:cubicBezTo>
                        <a:pt x="39527" y="46884"/>
                        <a:pt x="46603" y="36628"/>
                        <a:pt x="46603" y="23691"/>
                      </a:cubicBezTo>
                      <a:cubicBezTo>
                        <a:pt x="46603" y="11721"/>
                        <a:pt x="40587" y="2057"/>
                        <a:pt x="32357" y="0"/>
                      </a:cubicBezTo>
                    </a:path>
                  </a:pathLst>
                </a:custGeom>
                <a:noFill/>
                <a:ln w="9347" cap="rnd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2" name="Freeform: Shape 31">
                  <a:extLst>
                    <a:ext uri="{FF2B5EF4-FFF2-40B4-BE49-F238E27FC236}">
                      <a16:creationId xmlns:a16="http://schemas.microsoft.com/office/drawing/2014/main" id="{3CD970FB-EC54-0097-3B12-9251CDE5DE22}"/>
                    </a:ext>
                  </a:extLst>
                </p:cNvPr>
                <p:cNvSpPr/>
                <p:nvPr/>
              </p:nvSpPr>
              <p:spPr>
                <a:xfrm>
                  <a:off x="3344601" y="1672728"/>
                  <a:ext cx="114653" cy="262287"/>
                </a:xfrm>
                <a:custGeom>
                  <a:avLst/>
                  <a:gdLst>
                    <a:gd name="connsiteX0" fmla="*/ 81891 w 114653"/>
                    <a:gd name="connsiteY0" fmla="*/ 0 h 262287"/>
                    <a:gd name="connsiteX1" fmla="*/ 68112 w 114653"/>
                    <a:gd name="connsiteY1" fmla="*/ 23567 h 262287"/>
                    <a:gd name="connsiteX2" fmla="*/ 84353 w 114653"/>
                    <a:gd name="connsiteY2" fmla="*/ 47570 h 262287"/>
                    <a:gd name="connsiteX3" fmla="*/ 114653 w 114653"/>
                    <a:gd name="connsiteY3" fmla="*/ 95202 h 262287"/>
                    <a:gd name="connsiteX4" fmla="*/ 112284 w 114653"/>
                    <a:gd name="connsiteY4" fmla="*/ 115651 h 262287"/>
                    <a:gd name="connsiteX5" fmla="*/ 107390 w 114653"/>
                    <a:gd name="connsiteY5" fmla="*/ 123694 h 262287"/>
                    <a:gd name="connsiteX6" fmla="*/ 104242 w 114653"/>
                    <a:gd name="connsiteY6" fmla="*/ 125159 h 262287"/>
                    <a:gd name="connsiteX7" fmla="*/ 52744 w 114653"/>
                    <a:gd name="connsiteY7" fmla="*/ 140090 h 262287"/>
                    <a:gd name="connsiteX8" fmla="*/ 32544 w 114653"/>
                    <a:gd name="connsiteY8" fmla="*/ 150658 h 262287"/>
                    <a:gd name="connsiteX9" fmla="*/ 12095 w 114653"/>
                    <a:gd name="connsiteY9" fmla="*/ 184823 h 262287"/>
                    <a:gd name="connsiteX10" fmla="*/ 0 w 114653"/>
                    <a:gd name="connsiteY10" fmla="*/ 245329 h 262287"/>
                    <a:gd name="connsiteX11" fmla="*/ 81797 w 114653"/>
                    <a:gd name="connsiteY11" fmla="*/ 262287 h 26228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</a:cxnLst>
                  <a:rect l="l" t="t" r="r" b="b"/>
                  <a:pathLst>
                    <a:path w="114653" h="262287">
                      <a:moveTo>
                        <a:pt x="81891" y="0"/>
                      </a:moveTo>
                      <a:cubicBezTo>
                        <a:pt x="73911" y="2276"/>
                        <a:pt x="68112" y="11815"/>
                        <a:pt x="68112" y="23567"/>
                      </a:cubicBezTo>
                      <a:cubicBezTo>
                        <a:pt x="68112" y="36503"/>
                        <a:pt x="75157" y="46728"/>
                        <a:pt x="84353" y="47570"/>
                      </a:cubicBezTo>
                      <a:cubicBezTo>
                        <a:pt x="89528" y="67146"/>
                        <a:pt x="100220" y="83948"/>
                        <a:pt x="114653" y="95202"/>
                      </a:cubicBezTo>
                      <a:lnTo>
                        <a:pt x="112284" y="115651"/>
                      </a:lnTo>
                      <a:cubicBezTo>
                        <a:pt x="111910" y="118924"/>
                        <a:pt x="110133" y="121854"/>
                        <a:pt x="107390" y="123694"/>
                      </a:cubicBezTo>
                      <a:cubicBezTo>
                        <a:pt x="106424" y="124348"/>
                        <a:pt x="105364" y="124847"/>
                        <a:pt x="104242" y="125159"/>
                      </a:cubicBezTo>
                      <a:lnTo>
                        <a:pt x="52744" y="140090"/>
                      </a:lnTo>
                      <a:cubicBezTo>
                        <a:pt x="46073" y="141555"/>
                        <a:pt x="39247" y="145109"/>
                        <a:pt x="32544" y="150658"/>
                      </a:cubicBezTo>
                      <a:cubicBezTo>
                        <a:pt x="21977" y="159386"/>
                        <a:pt x="14745" y="171512"/>
                        <a:pt x="12095" y="184823"/>
                      </a:cubicBezTo>
                      <a:lnTo>
                        <a:pt x="0" y="245329"/>
                      </a:lnTo>
                      <a:lnTo>
                        <a:pt x="81797" y="262287"/>
                      </a:lnTo>
                    </a:path>
                  </a:pathLst>
                </a:custGeom>
                <a:noFill/>
                <a:ln w="9347" cap="rnd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sp>
            <p:nvSpPr>
              <p:cNvPr id="21" name="Freeform: Shape 20">
                <a:extLst>
                  <a:ext uri="{FF2B5EF4-FFF2-40B4-BE49-F238E27FC236}">
                    <a16:creationId xmlns:a16="http://schemas.microsoft.com/office/drawing/2014/main" id="{ED959F5E-3DBC-E64B-EF67-8FDADB27ACF6}"/>
                  </a:ext>
                </a:extLst>
              </p:cNvPr>
              <p:cNvSpPr/>
              <p:nvPr/>
            </p:nvSpPr>
            <p:spPr>
              <a:xfrm>
                <a:off x="3426461" y="1635944"/>
                <a:ext cx="5517" cy="36783"/>
              </a:xfrm>
              <a:custGeom>
                <a:avLst/>
                <a:gdLst>
                  <a:gd name="connsiteX0" fmla="*/ 5517 w 5517"/>
                  <a:gd name="connsiteY0" fmla="*/ 0 h 36783"/>
                  <a:gd name="connsiteX1" fmla="*/ 31 w 5517"/>
                  <a:gd name="connsiteY1" fmla="*/ 36784 h 367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517" h="36783">
                    <a:moveTo>
                      <a:pt x="5517" y="0"/>
                    </a:moveTo>
                    <a:cubicBezTo>
                      <a:pt x="-748" y="19234"/>
                      <a:pt x="31" y="36784"/>
                      <a:pt x="31" y="36784"/>
                    </a:cubicBezTo>
                  </a:path>
                </a:pathLst>
              </a:custGeom>
              <a:noFill/>
              <a:ln w="9347" cap="rnd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22" name="Freeform: Shape 21">
                <a:extLst>
                  <a:ext uri="{FF2B5EF4-FFF2-40B4-BE49-F238E27FC236}">
                    <a16:creationId xmlns:a16="http://schemas.microsoft.com/office/drawing/2014/main" id="{353F7497-6AF6-2F33-F9FE-B3A201C79587}"/>
                  </a:ext>
                </a:extLst>
              </p:cNvPr>
              <p:cNvSpPr/>
              <p:nvPr/>
            </p:nvSpPr>
            <p:spPr>
              <a:xfrm>
                <a:off x="3566925" y="1635726"/>
                <a:ext cx="5372" cy="36877"/>
              </a:xfrm>
              <a:custGeom>
                <a:avLst/>
                <a:gdLst>
                  <a:gd name="connsiteX0" fmla="*/ 5331 w 5372"/>
                  <a:gd name="connsiteY0" fmla="*/ 36877 h 36877"/>
                  <a:gd name="connsiteX1" fmla="*/ 0 w 5372"/>
                  <a:gd name="connsiteY1" fmla="*/ 0 h 368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372" h="36877">
                    <a:moveTo>
                      <a:pt x="5331" y="36877"/>
                    </a:moveTo>
                    <a:cubicBezTo>
                      <a:pt x="5331" y="36877"/>
                      <a:pt x="6203" y="19265"/>
                      <a:pt x="0" y="0"/>
                    </a:cubicBezTo>
                  </a:path>
                </a:pathLst>
              </a:custGeom>
              <a:noFill/>
              <a:ln w="9347" cap="rnd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23" name="Freeform: Shape 22">
                <a:extLst>
                  <a:ext uri="{FF2B5EF4-FFF2-40B4-BE49-F238E27FC236}">
                    <a16:creationId xmlns:a16="http://schemas.microsoft.com/office/drawing/2014/main" id="{11285F5A-5F15-2A3D-6A7E-69223D3A909B}"/>
                  </a:ext>
                </a:extLst>
              </p:cNvPr>
              <p:cNvSpPr/>
              <p:nvPr/>
            </p:nvSpPr>
            <p:spPr>
              <a:xfrm>
                <a:off x="3431978" y="1621033"/>
                <a:ext cx="134946" cy="22446"/>
              </a:xfrm>
              <a:custGeom>
                <a:avLst/>
                <a:gdLst>
                  <a:gd name="connsiteX0" fmla="*/ 134947 w 134946"/>
                  <a:gd name="connsiteY0" fmla="*/ 14693 h 22446"/>
                  <a:gd name="connsiteX1" fmla="*/ 91118 w 134946"/>
                  <a:gd name="connsiteY1" fmla="*/ 21832 h 22446"/>
                  <a:gd name="connsiteX2" fmla="*/ 47476 w 134946"/>
                  <a:gd name="connsiteY2" fmla="*/ 5560 h 22446"/>
                  <a:gd name="connsiteX3" fmla="*/ 15275 w 134946"/>
                  <a:gd name="connsiteY3" fmla="*/ 1726 h 22446"/>
                  <a:gd name="connsiteX4" fmla="*/ 0 w 134946"/>
                  <a:gd name="connsiteY4" fmla="*/ 14912 h 224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34946" h="22446">
                    <a:moveTo>
                      <a:pt x="134947" y="14693"/>
                    </a:moveTo>
                    <a:cubicBezTo>
                      <a:pt x="120950" y="21832"/>
                      <a:pt x="106704" y="23546"/>
                      <a:pt x="91118" y="21832"/>
                    </a:cubicBezTo>
                    <a:cubicBezTo>
                      <a:pt x="74783" y="20024"/>
                      <a:pt x="62034" y="12200"/>
                      <a:pt x="47476" y="5560"/>
                    </a:cubicBezTo>
                    <a:cubicBezTo>
                      <a:pt x="37376" y="946"/>
                      <a:pt x="25686" y="-2078"/>
                      <a:pt x="15275" y="1726"/>
                    </a:cubicBezTo>
                    <a:cubicBezTo>
                      <a:pt x="8853" y="4063"/>
                      <a:pt x="2992" y="8771"/>
                      <a:pt x="0" y="14912"/>
                    </a:cubicBezTo>
                  </a:path>
                </a:pathLst>
              </a:custGeom>
              <a:noFill/>
              <a:ln w="9347" cap="rnd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24" name="Freeform: Shape 23">
                <a:extLst>
                  <a:ext uri="{FF2B5EF4-FFF2-40B4-BE49-F238E27FC236}">
                    <a16:creationId xmlns:a16="http://schemas.microsoft.com/office/drawing/2014/main" id="{4040E244-C974-7D6B-25C3-8580C8C1B49F}"/>
                  </a:ext>
                </a:extLst>
              </p:cNvPr>
              <p:cNvSpPr/>
              <p:nvPr/>
            </p:nvSpPr>
            <p:spPr>
              <a:xfrm>
                <a:off x="3457477" y="1783578"/>
                <a:ext cx="84259" cy="37750"/>
              </a:xfrm>
              <a:custGeom>
                <a:avLst/>
                <a:gdLst>
                  <a:gd name="connsiteX0" fmla="*/ 84260 w 84259"/>
                  <a:gd name="connsiteY0" fmla="*/ 0 h 37750"/>
                  <a:gd name="connsiteX1" fmla="*/ 42114 w 84259"/>
                  <a:gd name="connsiteY1" fmla="*/ 37750 h 37750"/>
                  <a:gd name="connsiteX2" fmla="*/ 0 w 84259"/>
                  <a:gd name="connsiteY2" fmla="*/ 0 h 377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84259" h="37750">
                    <a:moveTo>
                      <a:pt x="84260" y="0"/>
                    </a:moveTo>
                    <a:lnTo>
                      <a:pt x="42114" y="37750"/>
                    </a:lnTo>
                    <a:lnTo>
                      <a:pt x="0" y="0"/>
                    </a:lnTo>
                  </a:path>
                </a:pathLst>
              </a:custGeom>
              <a:noFill/>
              <a:ln w="9347" cap="rnd">
                <a:solidFill>
                  <a:schemeClr val="bg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25" name="Freeform: Shape 24">
                <a:extLst>
                  <a:ext uri="{FF2B5EF4-FFF2-40B4-BE49-F238E27FC236}">
                    <a16:creationId xmlns:a16="http://schemas.microsoft.com/office/drawing/2014/main" id="{F5F2F1B7-3D92-6146-B928-3FBE9AD0E9F6}"/>
                  </a:ext>
                </a:extLst>
              </p:cNvPr>
              <p:cNvSpPr/>
              <p:nvPr/>
            </p:nvSpPr>
            <p:spPr>
              <a:xfrm>
                <a:off x="3566925" y="1876037"/>
                <a:ext cx="47663" cy="8977"/>
              </a:xfrm>
              <a:custGeom>
                <a:avLst/>
                <a:gdLst>
                  <a:gd name="connsiteX0" fmla="*/ 0 w 47663"/>
                  <a:gd name="connsiteY0" fmla="*/ 8978 h 8977"/>
                  <a:gd name="connsiteX1" fmla="*/ 47663 w 47663"/>
                  <a:gd name="connsiteY1" fmla="*/ 0 h 89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663" h="8977">
                    <a:moveTo>
                      <a:pt x="0" y="8978"/>
                    </a:moveTo>
                    <a:lnTo>
                      <a:pt x="47663" y="0"/>
                    </a:lnTo>
                  </a:path>
                </a:pathLst>
              </a:custGeom>
              <a:ln w="9347" cap="rnd">
                <a:solidFill>
                  <a:schemeClr val="bg1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26" name="Freeform: Shape 25">
                <a:extLst>
                  <a:ext uri="{FF2B5EF4-FFF2-40B4-BE49-F238E27FC236}">
                    <a16:creationId xmlns:a16="http://schemas.microsoft.com/office/drawing/2014/main" id="{DA460A97-6CB9-5F14-0C20-929FB30D44EB}"/>
                  </a:ext>
                </a:extLst>
              </p:cNvPr>
              <p:cNvSpPr/>
              <p:nvPr/>
            </p:nvSpPr>
            <p:spPr>
              <a:xfrm>
                <a:off x="3430669" y="1557919"/>
                <a:ext cx="136287" cy="82420"/>
              </a:xfrm>
              <a:custGeom>
                <a:avLst/>
                <a:gdLst>
                  <a:gd name="connsiteX0" fmla="*/ 0 w 136287"/>
                  <a:gd name="connsiteY0" fmla="*/ 82421 h 82420"/>
                  <a:gd name="connsiteX1" fmla="*/ 0 w 136287"/>
                  <a:gd name="connsiteY1" fmla="*/ 22569 h 82420"/>
                  <a:gd name="connsiteX2" fmla="*/ 22569 w 136287"/>
                  <a:gd name="connsiteY2" fmla="*/ 0 h 82420"/>
                  <a:gd name="connsiteX3" fmla="*/ 113718 w 136287"/>
                  <a:gd name="connsiteY3" fmla="*/ 0 h 82420"/>
                  <a:gd name="connsiteX4" fmla="*/ 136287 w 136287"/>
                  <a:gd name="connsiteY4" fmla="*/ 22569 h 82420"/>
                  <a:gd name="connsiteX5" fmla="*/ 136287 w 136287"/>
                  <a:gd name="connsiteY5" fmla="*/ 77807 h 824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36287" h="82420">
                    <a:moveTo>
                      <a:pt x="0" y="82421"/>
                    </a:moveTo>
                    <a:lnTo>
                      <a:pt x="0" y="22569"/>
                    </a:lnTo>
                    <a:cubicBezTo>
                      <a:pt x="0" y="10100"/>
                      <a:pt x="10100" y="0"/>
                      <a:pt x="22569" y="0"/>
                    </a:cubicBezTo>
                    <a:lnTo>
                      <a:pt x="113718" y="0"/>
                    </a:lnTo>
                    <a:cubicBezTo>
                      <a:pt x="126187" y="0"/>
                      <a:pt x="136287" y="10100"/>
                      <a:pt x="136287" y="22569"/>
                    </a:cubicBezTo>
                    <a:lnTo>
                      <a:pt x="136287" y="77807"/>
                    </a:lnTo>
                  </a:path>
                </a:pathLst>
              </a:custGeom>
              <a:noFill/>
              <a:ln w="9347" cap="rnd">
                <a:solidFill>
                  <a:schemeClr val="bg1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grpSp>
            <p:nvGrpSpPr>
              <p:cNvPr id="27" name="Graphic 4">
                <a:extLst>
                  <a:ext uri="{FF2B5EF4-FFF2-40B4-BE49-F238E27FC236}">
                    <a16:creationId xmlns:a16="http://schemas.microsoft.com/office/drawing/2014/main" id="{558A991E-2651-3BF3-F54A-7D41C86E021A}"/>
                  </a:ext>
                </a:extLst>
              </p:cNvPr>
              <p:cNvGrpSpPr/>
              <p:nvPr/>
            </p:nvGrpSpPr>
            <p:grpSpPr>
              <a:xfrm>
                <a:off x="3483008" y="1578306"/>
                <a:ext cx="31577" cy="31577"/>
                <a:chOff x="3483008" y="1578306"/>
                <a:chExt cx="31577" cy="31577"/>
              </a:xfrm>
            </p:grpSpPr>
            <p:sp>
              <p:nvSpPr>
                <p:cNvPr id="29" name="Freeform: Shape 28">
                  <a:extLst>
                    <a:ext uri="{FF2B5EF4-FFF2-40B4-BE49-F238E27FC236}">
                      <a16:creationId xmlns:a16="http://schemas.microsoft.com/office/drawing/2014/main" id="{102D5B9F-BBFE-22E4-055A-F9DB3C60B05E}"/>
                    </a:ext>
                  </a:extLst>
                </p:cNvPr>
                <p:cNvSpPr/>
                <p:nvPr/>
              </p:nvSpPr>
              <p:spPr>
                <a:xfrm>
                  <a:off x="3498781" y="1578306"/>
                  <a:ext cx="3117" cy="31577"/>
                </a:xfrm>
                <a:custGeom>
                  <a:avLst/>
                  <a:gdLst>
                    <a:gd name="connsiteX0" fmla="*/ 0 w 3117"/>
                    <a:gd name="connsiteY0" fmla="*/ 31578 h 31577"/>
                    <a:gd name="connsiteX1" fmla="*/ 0 w 3117"/>
                    <a:gd name="connsiteY1" fmla="*/ 0 h 3157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117" h="31577">
                      <a:moveTo>
                        <a:pt x="0" y="31578"/>
                      </a:moveTo>
                      <a:lnTo>
                        <a:pt x="0" y="0"/>
                      </a:lnTo>
                    </a:path>
                  </a:pathLst>
                </a:custGeom>
                <a:ln w="9347" cap="rnd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0" name="Freeform: Shape 29">
                  <a:extLst>
                    <a:ext uri="{FF2B5EF4-FFF2-40B4-BE49-F238E27FC236}">
                      <a16:creationId xmlns:a16="http://schemas.microsoft.com/office/drawing/2014/main" id="{534892B9-D022-1913-6EC4-73438CAC339C}"/>
                    </a:ext>
                  </a:extLst>
                </p:cNvPr>
                <p:cNvSpPr/>
                <p:nvPr/>
              </p:nvSpPr>
              <p:spPr>
                <a:xfrm>
                  <a:off x="3483008" y="1594079"/>
                  <a:ext cx="31577" cy="3117"/>
                </a:xfrm>
                <a:custGeom>
                  <a:avLst/>
                  <a:gdLst>
                    <a:gd name="connsiteX0" fmla="*/ 0 w 31577"/>
                    <a:gd name="connsiteY0" fmla="*/ 0 h 3117"/>
                    <a:gd name="connsiteX1" fmla="*/ 31578 w 31577"/>
                    <a:gd name="connsiteY1" fmla="*/ 0 h 311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1577" h="3117">
                      <a:moveTo>
                        <a:pt x="0" y="0"/>
                      </a:moveTo>
                      <a:lnTo>
                        <a:pt x="31578" y="0"/>
                      </a:lnTo>
                    </a:path>
                  </a:pathLst>
                </a:custGeom>
                <a:ln w="9347" cap="rnd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sp>
            <p:nvSpPr>
              <p:cNvPr id="28" name="Freeform: Shape 27">
                <a:extLst>
                  <a:ext uri="{FF2B5EF4-FFF2-40B4-BE49-F238E27FC236}">
                    <a16:creationId xmlns:a16="http://schemas.microsoft.com/office/drawing/2014/main" id="{C2187A2C-2CCB-AD73-8437-D6B5370858A4}"/>
                  </a:ext>
                </a:extLst>
              </p:cNvPr>
              <p:cNvSpPr/>
              <p:nvPr/>
            </p:nvSpPr>
            <p:spPr>
              <a:xfrm>
                <a:off x="3481324" y="1898980"/>
                <a:ext cx="36534" cy="52869"/>
              </a:xfrm>
              <a:custGeom>
                <a:avLst/>
                <a:gdLst>
                  <a:gd name="connsiteX0" fmla="*/ 0 w 36534"/>
                  <a:gd name="connsiteY0" fmla="*/ 32918 h 52869"/>
                  <a:gd name="connsiteX1" fmla="*/ 18267 w 36534"/>
                  <a:gd name="connsiteY1" fmla="*/ 52869 h 52869"/>
                  <a:gd name="connsiteX2" fmla="*/ 36535 w 36534"/>
                  <a:gd name="connsiteY2" fmla="*/ 32918 h 52869"/>
                  <a:gd name="connsiteX3" fmla="*/ 27806 w 36534"/>
                  <a:gd name="connsiteY3" fmla="*/ 0 h 52869"/>
                  <a:gd name="connsiteX4" fmla="*/ 6079 w 36534"/>
                  <a:gd name="connsiteY4" fmla="*/ 10007 h 52869"/>
                  <a:gd name="connsiteX5" fmla="*/ 0 w 36534"/>
                  <a:gd name="connsiteY5" fmla="*/ 32918 h 5286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36534" h="52869">
                    <a:moveTo>
                      <a:pt x="0" y="32918"/>
                    </a:moveTo>
                    <a:lnTo>
                      <a:pt x="18267" y="52869"/>
                    </a:lnTo>
                    <a:lnTo>
                      <a:pt x="36535" y="32918"/>
                    </a:lnTo>
                    <a:lnTo>
                      <a:pt x="27806" y="0"/>
                    </a:lnTo>
                    <a:cubicBezTo>
                      <a:pt x="19951" y="4770"/>
                      <a:pt x="12095" y="7949"/>
                      <a:pt x="6079" y="10007"/>
                    </a:cubicBezTo>
                    <a:lnTo>
                      <a:pt x="0" y="32918"/>
                    </a:lnTo>
                    <a:close/>
                  </a:path>
                </a:pathLst>
              </a:custGeom>
              <a:solidFill>
                <a:schemeClr val="bg1"/>
              </a:solidFill>
              <a:ln w="3116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  <p:sp>
          <p:nvSpPr>
            <p:cNvPr id="48" name="Oval 47">
              <a:extLst>
                <a:ext uri="{FF2B5EF4-FFF2-40B4-BE49-F238E27FC236}">
                  <a16:creationId xmlns:a16="http://schemas.microsoft.com/office/drawing/2014/main" id="{5DFBAB2D-AF52-3B40-A9A9-B53FBFD32640}"/>
                </a:ext>
              </a:extLst>
            </p:cNvPr>
            <p:cNvSpPr/>
            <p:nvPr/>
          </p:nvSpPr>
          <p:spPr>
            <a:xfrm>
              <a:off x="11011713" y="845575"/>
              <a:ext cx="533400" cy="533400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6" name="Oval 55">
            <a:extLst>
              <a:ext uri="{FF2B5EF4-FFF2-40B4-BE49-F238E27FC236}">
                <a16:creationId xmlns:a16="http://schemas.microsoft.com/office/drawing/2014/main" id="{FEBCE602-5148-1F2B-9A2C-475FEFB96B39}"/>
              </a:ext>
            </a:extLst>
          </p:cNvPr>
          <p:cNvSpPr/>
          <p:nvPr/>
        </p:nvSpPr>
        <p:spPr>
          <a:xfrm>
            <a:off x="645545" y="2317758"/>
            <a:ext cx="2076859" cy="2076859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49B5777-E0C2-17D9-277D-B25B57826412}"/>
              </a:ext>
            </a:extLst>
          </p:cNvPr>
          <p:cNvSpPr txBox="1"/>
          <p:nvPr/>
        </p:nvSpPr>
        <p:spPr>
          <a:xfrm>
            <a:off x="3730836" y="1455879"/>
            <a:ext cx="25556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+mj-lt"/>
              </a:rPr>
              <a:t>Parenteral Prostacyclin Initiation</a:t>
            </a:r>
            <a:endParaRPr lang="en-US" dirty="0">
              <a:solidFill>
                <a:srgbClr val="31489F"/>
              </a:solidFill>
              <a:latin typeface="+mj-lt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8ED4892-EA40-AF52-B544-30391E31E379}"/>
              </a:ext>
            </a:extLst>
          </p:cNvPr>
          <p:cNvSpPr txBox="1"/>
          <p:nvPr/>
        </p:nvSpPr>
        <p:spPr>
          <a:xfrm>
            <a:off x="9791700" y="1455879"/>
            <a:ext cx="224959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+mj-lt"/>
              </a:rPr>
              <a:t>First Comprehensive Follow-up Visit </a:t>
            </a:r>
            <a:endParaRPr lang="en-US" dirty="0">
              <a:solidFill>
                <a:srgbClr val="95A4DE"/>
              </a:solidFill>
              <a:latin typeface="+mj-lt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1E79AD5-525E-2113-0A77-A9068FCEAF93}"/>
              </a:ext>
            </a:extLst>
          </p:cNvPr>
          <p:cNvSpPr txBox="1"/>
          <p:nvPr/>
        </p:nvSpPr>
        <p:spPr>
          <a:xfrm>
            <a:off x="216906" y="4390889"/>
            <a:ext cx="2958374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dirty="0"/>
              <a:t>Included patients were classified as intermediate-low or intermediate-high risk per COMPERA 2.0 at index visit, initiated on a parenteral prostacyclin following intermediate risk assessment, had WHO FC, 6MWD, and BNP/NT-</a:t>
            </a:r>
            <a:r>
              <a:rPr lang="en-US" sz="1200" dirty="0" err="1"/>
              <a:t>proBNP</a:t>
            </a:r>
            <a:r>
              <a:rPr lang="en-US" sz="1200" dirty="0"/>
              <a:t> assessments at index and follow-up visits</a:t>
            </a:r>
          </a:p>
        </p:txBody>
      </p:sp>
      <p:sp>
        <p:nvSpPr>
          <p:cNvPr id="87" name="Arc 86">
            <a:extLst>
              <a:ext uri="{FF2B5EF4-FFF2-40B4-BE49-F238E27FC236}">
                <a16:creationId xmlns:a16="http://schemas.microsoft.com/office/drawing/2014/main" id="{4BC61417-8D64-1800-F8DE-F3956A0052E4}"/>
              </a:ext>
            </a:extLst>
          </p:cNvPr>
          <p:cNvSpPr/>
          <p:nvPr/>
        </p:nvSpPr>
        <p:spPr>
          <a:xfrm>
            <a:off x="459175" y="2131388"/>
            <a:ext cx="2449599" cy="2449599"/>
          </a:xfrm>
          <a:prstGeom prst="arc">
            <a:avLst>
              <a:gd name="adj1" fmla="val 7679554"/>
              <a:gd name="adj2" fmla="val 3132445"/>
            </a:avLst>
          </a:prstGeom>
          <a:ln w="25400" cap="rnd">
            <a:solidFill>
              <a:srgbClr val="95A4DE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Arrow: Right 105">
            <a:extLst>
              <a:ext uri="{FF2B5EF4-FFF2-40B4-BE49-F238E27FC236}">
                <a16:creationId xmlns:a16="http://schemas.microsoft.com/office/drawing/2014/main" id="{136047F9-83B3-5CE1-9AC9-8BD683610AFF}"/>
              </a:ext>
            </a:extLst>
          </p:cNvPr>
          <p:cNvSpPr/>
          <p:nvPr/>
        </p:nvSpPr>
        <p:spPr>
          <a:xfrm>
            <a:off x="2829701" y="3193466"/>
            <a:ext cx="283759" cy="321716"/>
          </a:xfrm>
          <a:prstGeom prst="rightArrow">
            <a:avLst>
              <a:gd name="adj1" fmla="val 100000"/>
              <a:gd name="adj2" fmla="val 100000"/>
            </a:avLst>
          </a:prstGeom>
          <a:solidFill>
            <a:srgbClr val="95A4DE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BD04C2AA-91DF-54BA-5F83-AD7F07811641}"/>
              </a:ext>
            </a:extLst>
          </p:cNvPr>
          <p:cNvCxnSpPr>
            <a:cxnSpLocks/>
          </p:cNvCxnSpPr>
          <p:nvPr/>
        </p:nvCxnSpPr>
        <p:spPr>
          <a:xfrm>
            <a:off x="6219825" y="1636136"/>
            <a:ext cx="3113457" cy="0"/>
          </a:xfrm>
          <a:prstGeom prst="straightConnector1">
            <a:avLst/>
          </a:prstGeom>
          <a:ln w="12700" cap="rnd">
            <a:solidFill>
              <a:schemeClr val="tx1"/>
            </a:solidFill>
            <a:round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Double Bracket 114">
            <a:extLst>
              <a:ext uri="{FF2B5EF4-FFF2-40B4-BE49-F238E27FC236}">
                <a16:creationId xmlns:a16="http://schemas.microsoft.com/office/drawing/2014/main" id="{F7FB1DF0-2090-4066-026C-E405404FC84C}"/>
              </a:ext>
            </a:extLst>
          </p:cNvPr>
          <p:cNvSpPr/>
          <p:nvPr/>
        </p:nvSpPr>
        <p:spPr>
          <a:xfrm>
            <a:off x="7289060" y="1496222"/>
            <a:ext cx="942975" cy="290420"/>
          </a:xfrm>
          <a:prstGeom prst="bracketPair">
            <a:avLst>
              <a:gd name="adj" fmla="val 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+mj-lt"/>
              </a:rPr>
              <a:t>3 months*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824159AA-2D4C-EB34-3EB7-678866E75412}"/>
              </a:ext>
            </a:extLst>
          </p:cNvPr>
          <p:cNvSpPr/>
          <p:nvPr/>
        </p:nvSpPr>
        <p:spPr>
          <a:xfrm>
            <a:off x="333716" y="1464459"/>
            <a:ext cx="171946" cy="171946"/>
          </a:xfrm>
          <a:prstGeom prst="ellipse">
            <a:avLst/>
          </a:prstGeom>
          <a:solidFill>
            <a:srgbClr val="95A4DE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E766FB-E8AE-C757-C12B-0FD29045607C}"/>
              </a:ext>
            </a:extLst>
          </p:cNvPr>
          <p:cNvSpPr txBox="1"/>
          <p:nvPr/>
        </p:nvSpPr>
        <p:spPr>
          <a:xfrm>
            <a:off x="505662" y="1373929"/>
            <a:ext cx="2844190" cy="461665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sz="1200" dirty="0"/>
              <a:t>HCPs: 53% community-based, 47% PH Care Center-based</a:t>
            </a:r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EC3AAA0F-9604-7153-232D-2DCEDA338182}"/>
              </a:ext>
            </a:extLst>
          </p:cNvPr>
          <p:cNvSpPr/>
          <p:nvPr/>
        </p:nvSpPr>
        <p:spPr>
          <a:xfrm>
            <a:off x="333716" y="1844037"/>
            <a:ext cx="171946" cy="171946"/>
          </a:xfrm>
          <a:prstGeom prst="ellipse">
            <a:avLst/>
          </a:prstGeom>
          <a:solidFill>
            <a:srgbClr val="95A4DE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DC6418C-49C3-7206-4DA1-D106E487E510}"/>
              </a:ext>
            </a:extLst>
          </p:cNvPr>
          <p:cNvSpPr txBox="1"/>
          <p:nvPr/>
        </p:nvSpPr>
        <p:spPr>
          <a:xfrm>
            <a:off x="505662" y="1791511"/>
            <a:ext cx="2844190" cy="27699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sz="1200" dirty="0"/>
              <a:t>Patients: 54.1 mean age, 52% female</a:t>
            </a:r>
          </a:p>
        </p:txBody>
      </p:sp>
      <p:graphicFrame>
        <p:nvGraphicFramePr>
          <p:cNvPr id="50" name="Chart 49">
            <a:extLst>
              <a:ext uri="{FF2B5EF4-FFF2-40B4-BE49-F238E27FC236}">
                <a16:creationId xmlns:a16="http://schemas.microsoft.com/office/drawing/2014/main" id="{B9CDBC69-79DE-DB07-43CA-EF84F9383A9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93026769"/>
              </p:ext>
            </p:extLst>
          </p:nvPr>
        </p:nvGraphicFramePr>
        <p:xfrm>
          <a:off x="3479799" y="2245162"/>
          <a:ext cx="8553361" cy="12620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1" name="Rectangle 50">
            <a:extLst>
              <a:ext uri="{FF2B5EF4-FFF2-40B4-BE49-F238E27FC236}">
                <a16:creationId xmlns:a16="http://schemas.microsoft.com/office/drawing/2014/main" id="{4497A9FF-59EE-C535-7BDB-A660FEEC2772}"/>
              </a:ext>
            </a:extLst>
          </p:cNvPr>
          <p:cNvSpPr/>
          <p:nvPr/>
        </p:nvSpPr>
        <p:spPr>
          <a:xfrm>
            <a:off x="3471666" y="2229871"/>
            <a:ext cx="8561494" cy="12773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endParaRPr lang="en-US" sz="1600" b="1" dirty="0">
              <a:solidFill>
                <a:schemeClr val="tx1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74012B0-1648-A2E7-540D-B2C404274571}"/>
              </a:ext>
            </a:extLst>
          </p:cNvPr>
          <p:cNvSpPr txBox="1"/>
          <p:nvPr/>
        </p:nvSpPr>
        <p:spPr>
          <a:xfrm>
            <a:off x="3883024" y="2083879"/>
            <a:ext cx="1057275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Risk Level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156A7ABB-B441-A041-823E-592DFD00A239}"/>
              </a:ext>
            </a:extLst>
          </p:cNvPr>
          <p:cNvSpPr/>
          <p:nvPr/>
        </p:nvSpPr>
        <p:spPr>
          <a:xfrm>
            <a:off x="3471667" y="1554318"/>
            <a:ext cx="258959" cy="488622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B719C41A-AFF6-0E2F-41F7-9FCB5E966BED}"/>
              </a:ext>
            </a:extLst>
          </p:cNvPr>
          <p:cNvSpPr/>
          <p:nvPr/>
        </p:nvSpPr>
        <p:spPr>
          <a:xfrm>
            <a:off x="9532741" y="1554318"/>
            <a:ext cx="258959" cy="488622"/>
          </a:xfrm>
          <a:prstGeom prst="rect">
            <a:avLst/>
          </a:prstGeom>
          <a:pattFill prst="wdDnDiag">
            <a:fgClr>
              <a:schemeClr val="tx1">
                <a:lumMod val="50000"/>
                <a:lumOff val="50000"/>
              </a:schemeClr>
            </a:fgClr>
            <a:bgClr>
              <a:schemeClr val="bg1"/>
            </a:bgClr>
          </a:patt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77" name="Chart 76">
            <a:extLst>
              <a:ext uri="{FF2B5EF4-FFF2-40B4-BE49-F238E27FC236}">
                <a16:creationId xmlns:a16="http://schemas.microsoft.com/office/drawing/2014/main" id="{484894EE-2214-C4EF-4B80-8A58535540A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765577281"/>
              </p:ext>
            </p:extLst>
          </p:nvPr>
        </p:nvGraphicFramePr>
        <p:xfrm>
          <a:off x="3479799" y="3686315"/>
          <a:ext cx="8553361" cy="12620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8" name="Rectangle 77">
            <a:extLst>
              <a:ext uri="{FF2B5EF4-FFF2-40B4-BE49-F238E27FC236}">
                <a16:creationId xmlns:a16="http://schemas.microsoft.com/office/drawing/2014/main" id="{50749C69-20E9-23C7-F960-66700CB5253E}"/>
              </a:ext>
            </a:extLst>
          </p:cNvPr>
          <p:cNvSpPr/>
          <p:nvPr/>
        </p:nvSpPr>
        <p:spPr>
          <a:xfrm>
            <a:off x="3471666" y="3671024"/>
            <a:ext cx="8561494" cy="12773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endParaRPr lang="en-US" sz="1600" b="1" dirty="0">
              <a:solidFill>
                <a:schemeClr val="tx1"/>
              </a:solidFill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9082C16-C9DE-F5CC-6B40-711CDCBAA668}"/>
              </a:ext>
            </a:extLst>
          </p:cNvPr>
          <p:cNvSpPr txBox="1"/>
          <p:nvPr/>
        </p:nvSpPr>
        <p:spPr>
          <a:xfrm>
            <a:off x="3883024" y="3525032"/>
            <a:ext cx="1971568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WHO FC Assessment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950D2D2C-8F4E-97C9-0556-BCB2D505BCE1}"/>
              </a:ext>
            </a:extLst>
          </p:cNvPr>
          <p:cNvSpPr/>
          <p:nvPr/>
        </p:nvSpPr>
        <p:spPr>
          <a:xfrm>
            <a:off x="3471666" y="5121798"/>
            <a:ext cx="2958374" cy="12773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endParaRPr lang="en-US" sz="1600" b="1" dirty="0">
              <a:solidFill>
                <a:schemeClr val="tx1"/>
              </a:solidFill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569C27C-C809-0CFB-B464-57646D6ADBE1}"/>
              </a:ext>
            </a:extLst>
          </p:cNvPr>
          <p:cNvSpPr txBox="1"/>
          <p:nvPr/>
        </p:nvSpPr>
        <p:spPr>
          <a:xfrm>
            <a:off x="3883024" y="4975806"/>
            <a:ext cx="1902434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6MWD Assessment</a:t>
            </a:r>
          </a:p>
        </p:txBody>
      </p:sp>
      <p:graphicFrame>
        <p:nvGraphicFramePr>
          <p:cNvPr id="82" name="Chart 81">
            <a:extLst>
              <a:ext uri="{FF2B5EF4-FFF2-40B4-BE49-F238E27FC236}">
                <a16:creationId xmlns:a16="http://schemas.microsoft.com/office/drawing/2014/main" id="{D25BB03C-4209-EF4E-0C98-79EBB47DA2C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070537687"/>
              </p:ext>
            </p:extLst>
          </p:nvPr>
        </p:nvGraphicFramePr>
        <p:xfrm>
          <a:off x="3479799" y="5137089"/>
          <a:ext cx="2921001" cy="12620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0" name="Rectangle 89">
            <a:extLst>
              <a:ext uri="{FF2B5EF4-FFF2-40B4-BE49-F238E27FC236}">
                <a16:creationId xmlns:a16="http://schemas.microsoft.com/office/drawing/2014/main" id="{A2C65F76-542B-5743-6EBF-564E85A81C54}"/>
              </a:ext>
            </a:extLst>
          </p:cNvPr>
          <p:cNvSpPr/>
          <p:nvPr/>
        </p:nvSpPr>
        <p:spPr>
          <a:xfrm>
            <a:off x="6562277" y="5121798"/>
            <a:ext cx="5479015" cy="12773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endParaRPr lang="en-US" sz="1600" b="1" dirty="0">
              <a:solidFill>
                <a:schemeClr val="tx1"/>
              </a:solidFill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63647353-465E-2670-34F5-6AA5B2349744}"/>
              </a:ext>
            </a:extLst>
          </p:cNvPr>
          <p:cNvSpPr txBox="1"/>
          <p:nvPr/>
        </p:nvSpPr>
        <p:spPr>
          <a:xfrm>
            <a:off x="6918216" y="4975806"/>
            <a:ext cx="2656232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BNP/NT-</a:t>
            </a:r>
            <a:r>
              <a:rPr lang="en-US" sz="1600" b="1" dirty="0" err="1">
                <a:solidFill>
                  <a:schemeClr val="tx1"/>
                </a:solidFill>
              </a:rPr>
              <a:t>proBNP</a:t>
            </a:r>
            <a:r>
              <a:rPr lang="en-US" sz="1600" b="1" dirty="0">
                <a:solidFill>
                  <a:schemeClr val="tx1"/>
                </a:solidFill>
              </a:rPr>
              <a:t> Assessment</a:t>
            </a:r>
          </a:p>
        </p:txBody>
      </p:sp>
      <p:graphicFrame>
        <p:nvGraphicFramePr>
          <p:cNvPr id="92" name="Chart 91">
            <a:extLst>
              <a:ext uri="{FF2B5EF4-FFF2-40B4-BE49-F238E27FC236}">
                <a16:creationId xmlns:a16="http://schemas.microsoft.com/office/drawing/2014/main" id="{661BDA5E-7E3B-4E16-93F2-EC3D7080356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12759409"/>
              </p:ext>
            </p:extLst>
          </p:nvPr>
        </p:nvGraphicFramePr>
        <p:xfrm>
          <a:off x="6570411" y="5137089"/>
          <a:ext cx="5479015" cy="12620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1" name="Group 10">
            <a:extLst>
              <a:ext uri="{FF2B5EF4-FFF2-40B4-BE49-F238E27FC236}">
                <a16:creationId xmlns:a16="http://schemas.microsoft.com/office/drawing/2014/main" id="{621EBAF0-B693-DC7D-01BF-1A49BE55A35C}"/>
              </a:ext>
            </a:extLst>
          </p:cNvPr>
          <p:cNvGrpSpPr/>
          <p:nvPr/>
        </p:nvGrpSpPr>
        <p:grpSpPr>
          <a:xfrm>
            <a:off x="3143294" y="3753688"/>
            <a:ext cx="660735" cy="660735"/>
            <a:chOff x="3143294" y="2361321"/>
            <a:chExt cx="660735" cy="660735"/>
          </a:xfrm>
        </p:grpSpPr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8DAFA7F4-50DF-002F-C678-E99DECF94971}"/>
                </a:ext>
              </a:extLst>
            </p:cNvPr>
            <p:cNvSpPr/>
            <p:nvPr/>
          </p:nvSpPr>
          <p:spPr>
            <a:xfrm>
              <a:off x="3143294" y="2361321"/>
              <a:ext cx="660735" cy="660735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9" name="Graphic 8">
              <a:extLst>
                <a:ext uri="{FF2B5EF4-FFF2-40B4-BE49-F238E27FC236}">
                  <a16:creationId xmlns:a16="http://schemas.microsoft.com/office/drawing/2014/main" id="{BECA8202-62EC-37D7-092E-E5B53B10451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3182218" y="2400245"/>
              <a:ext cx="582887" cy="582887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E74211E2-A9B3-5BDD-6AAA-70C372BBDC4A}"/>
              </a:ext>
            </a:extLst>
          </p:cNvPr>
          <p:cNvGrpSpPr/>
          <p:nvPr/>
        </p:nvGrpSpPr>
        <p:grpSpPr>
          <a:xfrm>
            <a:off x="3143294" y="2297309"/>
            <a:ext cx="660735" cy="660735"/>
            <a:chOff x="3143294" y="2361321"/>
            <a:chExt cx="660735" cy="660735"/>
          </a:xfrm>
        </p:grpSpPr>
        <p:sp>
          <p:nvSpPr>
            <p:cNvPr id="49" name="Oval 48">
              <a:extLst>
                <a:ext uri="{FF2B5EF4-FFF2-40B4-BE49-F238E27FC236}">
                  <a16:creationId xmlns:a16="http://schemas.microsoft.com/office/drawing/2014/main" id="{B568C009-329D-8E19-F1C7-047BB9930111}"/>
                </a:ext>
              </a:extLst>
            </p:cNvPr>
            <p:cNvSpPr/>
            <p:nvPr/>
          </p:nvSpPr>
          <p:spPr>
            <a:xfrm>
              <a:off x="3143294" y="2361321"/>
              <a:ext cx="660735" cy="660735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52" name="Graphic 51">
              <a:extLst>
                <a:ext uri="{FF2B5EF4-FFF2-40B4-BE49-F238E27FC236}">
                  <a16:creationId xmlns:a16="http://schemas.microsoft.com/office/drawing/2014/main" id="{FED9FB2A-F90C-8966-D714-4AE7C4E9701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9"/>
                </a:ext>
              </a:extLst>
            </a:blip>
            <a:srcRect/>
            <a:stretch/>
          </p:blipFill>
          <p:spPr>
            <a:xfrm>
              <a:off x="3182218" y="2400245"/>
              <a:ext cx="582887" cy="582887"/>
            </a:xfrm>
            <a:prstGeom prst="rect">
              <a:avLst/>
            </a:prstGeom>
          </p:spPr>
        </p:pic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F5FBC0DA-3141-7084-1022-0C8B41079EC1}"/>
              </a:ext>
            </a:extLst>
          </p:cNvPr>
          <p:cNvGrpSpPr/>
          <p:nvPr/>
        </p:nvGrpSpPr>
        <p:grpSpPr>
          <a:xfrm>
            <a:off x="3143294" y="5225775"/>
            <a:ext cx="660735" cy="660735"/>
            <a:chOff x="3143294" y="2361321"/>
            <a:chExt cx="660735" cy="660735"/>
          </a:xfrm>
        </p:grpSpPr>
        <p:sp>
          <p:nvSpPr>
            <p:cNvPr id="74" name="Oval 73">
              <a:extLst>
                <a:ext uri="{FF2B5EF4-FFF2-40B4-BE49-F238E27FC236}">
                  <a16:creationId xmlns:a16="http://schemas.microsoft.com/office/drawing/2014/main" id="{58E024BB-A7DF-223F-63F6-1C882B7815FB}"/>
                </a:ext>
              </a:extLst>
            </p:cNvPr>
            <p:cNvSpPr/>
            <p:nvPr/>
          </p:nvSpPr>
          <p:spPr>
            <a:xfrm>
              <a:off x="3143294" y="2361321"/>
              <a:ext cx="660735" cy="660735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75" name="Graphic 74">
              <a:extLst>
                <a:ext uri="{FF2B5EF4-FFF2-40B4-BE49-F238E27FC236}">
                  <a16:creationId xmlns:a16="http://schemas.microsoft.com/office/drawing/2014/main" id="{C0B4B1FC-52D4-AE34-29C1-113CEE288E5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1"/>
                </a:ext>
              </a:extLst>
            </a:blip>
            <a:srcRect/>
            <a:stretch/>
          </p:blipFill>
          <p:spPr>
            <a:xfrm>
              <a:off x="3182218" y="2400245"/>
              <a:ext cx="582887" cy="582887"/>
            </a:xfrm>
            <a:prstGeom prst="rect">
              <a:avLst/>
            </a:prstGeom>
          </p:spPr>
        </p:pic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8D6B5B8A-0DEF-286B-4A76-9F28E274F21C}"/>
              </a:ext>
            </a:extLst>
          </p:cNvPr>
          <p:cNvGrpSpPr/>
          <p:nvPr/>
        </p:nvGrpSpPr>
        <p:grpSpPr>
          <a:xfrm>
            <a:off x="6477049" y="5225775"/>
            <a:ext cx="660735" cy="660735"/>
            <a:chOff x="3143294" y="2361321"/>
            <a:chExt cx="660735" cy="660735"/>
          </a:xfrm>
        </p:grpSpPr>
        <p:sp>
          <p:nvSpPr>
            <p:cNvPr id="84" name="Oval 83">
              <a:extLst>
                <a:ext uri="{FF2B5EF4-FFF2-40B4-BE49-F238E27FC236}">
                  <a16:creationId xmlns:a16="http://schemas.microsoft.com/office/drawing/2014/main" id="{D64A854B-58C6-A441-E54F-4BF08A72796B}"/>
                </a:ext>
              </a:extLst>
            </p:cNvPr>
            <p:cNvSpPr/>
            <p:nvPr/>
          </p:nvSpPr>
          <p:spPr>
            <a:xfrm>
              <a:off x="3143294" y="2361321"/>
              <a:ext cx="660735" cy="660735"/>
            </a:xfrm>
            <a:prstGeom prst="ellipse">
              <a:avLst/>
            </a:prstGeom>
            <a:solidFill>
              <a:schemeClr val="accent5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5" name="Graphic 84">
              <a:extLst>
                <a:ext uri="{FF2B5EF4-FFF2-40B4-BE49-F238E27FC236}">
                  <a16:creationId xmlns:a16="http://schemas.microsoft.com/office/drawing/2014/main" id="{F79E2FA5-ADC1-01F5-FBF8-0E6473E319DA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3"/>
                </a:ext>
              </a:extLst>
            </a:blip>
            <a:srcRect/>
            <a:stretch/>
          </p:blipFill>
          <p:spPr>
            <a:xfrm>
              <a:off x="3182218" y="2400245"/>
              <a:ext cx="582887" cy="582887"/>
            </a:xfrm>
            <a:prstGeom prst="rect">
              <a:avLst/>
            </a:prstGeom>
          </p:spPr>
        </p:pic>
      </p:grpSp>
      <p:pic>
        <p:nvPicPr>
          <p:cNvPr id="88" name="Graphic 87">
            <a:extLst>
              <a:ext uri="{FF2B5EF4-FFF2-40B4-BE49-F238E27FC236}">
                <a16:creationId xmlns:a16="http://schemas.microsoft.com/office/drawing/2014/main" id="{272C95B8-E90A-5C05-06AD-3BD334302E7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703451" y="2328551"/>
            <a:ext cx="1947147" cy="1947147"/>
          </a:xfrm>
          <a:prstGeom prst="rect">
            <a:avLst/>
          </a:prstGeom>
        </p:spPr>
      </p:pic>
      <p:pic>
        <p:nvPicPr>
          <p:cNvPr id="93" name="Graphic 92">
            <a:extLst>
              <a:ext uri="{FF2B5EF4-FFF2-40B4-BE49-F238E27FC236}">
                <a16:creationId xmlns:a16="http://schemas.microsoft.com/office/drawing/2014/main" id="{0E784BFE-12D7-3A49-060C-BF564A383D7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10760882" y="647921"/>
            <a:ext cx="533400" cy="53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5988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Slipstream">
      <a:dk1>
        <a:sysClr val="windowText" lastClr="000000"/>
      </a:dk1>
      <a:lt1>
        <a:sysClr val="window" lastClr="FFFFFF"/>
      </a:lt1>
      <a:dk2>
        <a:srgbClr val="212745"/>
      </a:dk2>
      <a:lt2>
        <a:srgbClr val="B4DCFA"/>
      </a:lt2>
      <a:accent1>
        <a:srgbClr val="4E67C8"/>
      </a:accent1>
      <a:accent2>
        <a:srgbClr val="5ECCF3"/>
      </a:accent2>
      <a:accent3>
        <a:srgbClr val="A7EA52"/>
      </a:accent3>
      <a:accent4>
        <a:srgbClr val="5DCEAF"/>
      </a:accent4>
      <a:accent5>
        <a:srgbClr val="FF8021"/>
      </a:accent5>
      <a:accent6>
        <a:srgbClr val="F14124"/>
      </a:accent6>
      <a:hlink>
        <a:srgbClr val="56C7AA"/>
      </a:hlink>
      <a:folHlink>
        <a:srgbClr val="59A8D1"/>
      </a:folHlink>
    </a:clrScheme>
    <a:fontScheme name="Franklin Gothic">
      <a:majorFont>
        <a:latin typeface="Franklin Gothic Medium" panose="020B0603020102020204"/>
        <a:ea typeface=""/>
        <a:cs typeface=""/>
        <a:font script="Jpan" typeface="HG創英角ｺﾞｼｯｸUB"/>
        <a:font script="Hang" typeface="돋움"/>
        <a:font script="Hans" typeface="隶书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Franklin Gothic Book" panose="020B0503020102020204"/>
        <a:ea typeface=""/>
        <a:cs typeface=""/>
        <a:font script="Jpan" typeface="HGｺﾞｼｯｸE"/>
        <a:font script="Hang" typeface="돋움"/>
        <a:font script="Hans" typeface="华文楷体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3257231FC8AD340BDCD1B68850E92BA" ma:contentTypeVersion="14" ma:contentTypeDescription="Create a new document." ma:contentTypeScope="" ma:versionID="b9b56725e81be9d8cce362b3d564719c">
  <xsd:schema xmlns:xsd="http://www.w3.org/2001/XMLSchema" xmlns:xs="http://www.w3.org/2001/XMLSchema" xmlns:p="http://schemas.microsoft.com/office/2006/metadata/properties" xmlns:ns2="6c38dfd5-b50d-4b9d-ab34-3b9b70a1ee20" xmlns:ns3="277592ab-ffa8-40c6-a5e7-1af7831362d3" xmlns:ns4="4dc7260f-d498-4b80-8a56-fd954b4759cf" targetNamespace="http://schemas.microsoft.com/office/2006/metadata/properties" ma:root="true" ma:fieldsID="aa92fc165474a51b4c2115b682a601e4" ns2:_="" ns3:_="" ns4:_="">
    <xsd:import namespace="6c38dfd5-b50d-4b9d-ab34-3b9b70a1ee20"/>
    <xsd:import namespace="277592ab-ffa8-40c6-a5e7-1af7831362d3"/>
    <xsd:import namespace="4dc7260f-d498-4b80-8a56-fd954b4759c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4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c38dfd5-b50d-4b9d-ab34-3b9b70a1ee2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738e97db-eba0-44bb-9937-862161d7610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7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77592ab-ffa8-40c6-a5e7-1af7831362d3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dc7260f-d498-4b80-8a56-fd954b4759cf" elementFormDefault="qualified">
    <xsd:import namespace="http://schemas.microsoft.com/office/2006/documentManagement/types"/>
    <xsd:import namespace="http://schemas.microsoft.com/office/infopath/2007/PartnerControls"/>
    <xsd:element name="TaxCatchAll" ma:index="16" nillable="true" ma:displayName="Taxonomy Catch All Column" ma:hidden="true" ma:list="{CFA1CF97-F6D7-401F-A927-DD98B44AC1A0}" ma:internalName="TaxCatchAll" ma:showField="CatchAllData" ma:web="{277592ab-ffa8-40c6-a5e7-1af7831362d3}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dc7260f-d498-4b80-8a56-fd954b4759cf" xsi:nil="true"/>
    <lcf76f155ced4ddcb4097134ff3c332f xmlns="6c38dfd5-b50d-4b9d-ab34-3b9b70a1ee20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A80144B8-4037-483D-A1BE-7F5FD09FD46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4E9D4F9-39F6-46B8-A987-E495808FAA71}"/>
</file>

<file path=customXml/itemProps3.xml><?xml version="1.0" encoding="utf-8"?>
<ds:datastoreItem xmlns:ds="http://schemas.openxmlformats.org/officeDocument/2006/customXml" ds:itemID="{163B2B7E-9F86-430C-9279-E87811FF082F}">
  <ds:schemaRefs>
    <ds:schemaRef ds:uri="6c38dfd5-b50d-4b9d-ab34-3b9b70a1ee20"/>
    <ds:schemaRef ds:uri="http://schemas.microsoft.com/office/infopath/2007/PartnerControls"/>
    <ds:schemaRef ds:uri="http://schemas.microsoft.com/office/2006/metadata/properties"/>
    <ds:schemaRef ds:uri="http://purl.org/dc/dcmitype/"/>
    <ds:schemaRef ds:uri="4dc7260f-d498-4b80-8a56-fd954b4759cf"/>
    <ds:schemaRef ds:uri="http://purl.org/dc/terms/"/>
    <ds:schemaRef ds:uri="http://schemas.openxmlformats.org/package/2006/metadata/core-properties"/>
    <ds:schemaRef ds:uri="277592ab-ffa8-40c6-a5e7-1af7831362d3"/>
    <ds:schemaRef ds:uri="http://www.w3.org/XML/1998/namespace"/>
    <ds:schemaRef ds:uri="http://schemas.microsoft.com/office/2006/documentManagement/types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70</TotalTime>
  <Words>225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Franklin Gothic Book</vt:lpstr>
      <vt:lpstr>Franklin Gothic Medium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ssa Lippa</dc:creator>
  <cp:lastModifiedBy>Rebecca Hahn</cp:lastModifiedBy>
  <cp:revision>4</cp:revision>
  <dcterms:created xsi:type="dcterms:W3CDTF">2023-11-15T14:28:49Z</dcterms:created>
  <dcterms:modified xsi:type="dcterms:W3CDTF">2024-01-03T19:23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3257231FC8AD340BDCD1B68850E92BA</vt:lpwstr>
  </property>
  <property fmtid="{D5CDD505-2E9C-101B-9397-08002B2CF9AE}" pid="3" name="MSIP_Label_2c79f05a-81ce-4200-a14f-56138453d180_Enabled">
    <vt:lpwstr>true</vt:lpwstr>
  </property>
  <property fmtid="{D5CDD505-2E9C-101B-9397-08002B2CF9AE}" pid="4" name="MSIP_Label_2c79f05a-81ce-4200-a14f-56138453d180_SetDate">
    <vt:lpwstr>2023-11-15T15:31:14Z</vt:lpwstr>
  </property>
  <property fmtid="{D5CDD505-2E9C-101B-9397-08002B2CF9AE}" pid="5" name="MSIP_Label_2c79f05a-81ce-4200-a14f-56138453d180_Method">
    <vt:lpwstr>Privileged</vt:lpwstr>
  </property>
  <property fmtid="{D5CDD505-2E9C-101B-9397-08002B2CF9AE}" pid="6" name="MSIP_Label_2c79f05a-81ce-4200-a14f-56138453d180_Name">
    <vt:lpwstr>Confidential</vt:lpwstr>
  </property>
  <property fmtid="{D5CDD505-2E9C-101B-9397-08002B2CF9AE}" pid="7" name="MSIP_Label_2c79f05a-81ce-4200-a14f-56138453d180_SiteId">
    <vt:lpwstr>33d02ecf-ebd9-4397-ba9f-dcb57fb4ad3d</vt:lpwstr>
  </property>
  <property fmtid="{D5CDD505-2E9C-101B-9397-08002B2CF9AE}" pid="8" name="MSIP_Label_2c79f05a-81ce-4200-a14f-56138453d180_ActionId">
    <vt:lpwstr>24ab68b6-b471-41dc-90c0-d4794271db2c</vt:lpwstr>
  </property>
  <property fmtid="{D5CDD505-2E9C-101B-9397-08002B2CF9AE}" pid="9" name="MSIP_Label_2c79f05a-81ce-4200-a14f-56138453d180_ContentBits">
    <vt:lpwstr>0</vt:lpwstr>
  </property>
  <property fmtid="{D5CDD505-2E9C-101B-9397-08002B2CF9AE}" pid="10" name="MediaServiceImageTags">
    <vt:lpwstr/>
  </property>
</Properties>
</file>